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022CE-9EB2-4921-890C-AE555F9DFA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0B78D-CF55-4317-A9FC-C5D94F3CA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9755C-72FD-4047-ABA5-E6F142B3CD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FCE8C-44C3-449E-A747-99B734EE5A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A8A2D-008D-4A54-901D-50A5B7A1DD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C3EB3-8055-4AC1-9C80-D7F68A2276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32ADD-C4F5-48B8-972B-11C8DBA10D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FF3EF-94BA-41CD-B17B-4F4001CE27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4C636-46AC-4B63-B000-E34CAA2E16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4E4FD-5536-408A-A742-B93A707466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3D85B-EF14-40DD-A7E9-91AD417F6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346B4-0E63-455B-8CAA-E9F23A2396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3C1339-4339-4F0B-B834-F62722D946C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sp>
          <p:nvSpPr>
            <p:cNvPr id="42" name="Rectangle 1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3" name="Group 4"/>
            <p:cNvGrpSpPr/>
            <p:nvPr/>
          </p:nvGrpSpPr>
          <p:grpSpPr>
            <a:xfrm>
              <a:off x="34920" y="188640"/>
              <a:ext cx="8947440" cy="6213240"/>
              <a:chOff x="34920" y="188640"/>
              <a:chExt cx="8947440" cy="6213240"/>
            </a:xfrm>
          </p:grpSpPr>
          <p:grpSp>
            <p:nvGrpSpPr>
              <p:cNvPr id="44" name="Group 128"/>
              <p:cNvGrpSpPr/>
              <p:nvPr/>
            </p:nvGrpSpPr>
            <p:grpSpPr>
              <a:xfrm>
                <a:off x="266040" y="1007640"/>
                <a:ext cx="1619280" cy="1685880"/>
                <a:chOff x="266040" y="1007640"/>
                <a:chExt cx="1619280" cy="1685880"/>
              </a:xfrm>
            </p:grpSpPr>
            <p:sp>
              <p:nvSpPr>
                <p:cNvPr id="45" name="Oval 5"/>
                <p:cNvSpPr/>
                <p:nvPr/>
              </p:nvSpPr>
              <p:spPr>
                <a:xfrm>
                  <a:off x="266040" y="1007640"/>
                  <a:ext cx="161928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46" name="Group 6"/>
                <p:cNvGrpSpPr/>
                <p:nvPr/>
              </p:nvGrpSpPr>
              <p:grpSpPr>
                <a:xfrm>
                  <a:off x="1110240" y="1587600"/>
                  <a:ext cx="363240" cy="501840"/>
                  <a:chOff x="1110240" y="1587600"/>
                  <a:chExt cx="363240" cy="501840"/>
                </a:xfrm>
              </p:grpSpPr>
              <p:sp>
                <p:nvSpPr>
                  <p:cNvPr id="47" name="Oval 7"/>
                  <p:cNvSpPr/>
                  <p:nvPr/>
                </p:nvSpPr>
                <p:spPr>
                  <a:xfrm rot="19500000">
                    <a:off x="1172520" y="163044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" name="Oval 8"/>
                  <p:cNvSpPr/>
                  <p:nvPr/>
                </p:nvSpPr>
                <p:spPr>
                  <a:xfrm rot="19500000">
                    <a:off x="1356480" y="1820160"/>
                    <a:ext cx="54000" cy="2368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" name="Oval 9"/>
                  <p:cNvSpPr/>
                  <p:nvPr/>
                </p:nvSpPr>
                <p:spPr>
                  <a:xfrm rot="600000">
                    <a:off x="1311120" y="1590120"/>
                    <a:ext cx="55440" cy="2595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" name="Oval 10"/>
                  <p:cNvSpPr/>
                  <p:nvPr/>
                </p:nvSpPr>
                <p:spPr>
                  <a:xfrm rot="21300000">
                    <a:off x="1253520" y="185328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" name="Oval 11"/>
                  <p:cNvSpPr/>
                  <p:nvPr/>
                </p:nvSpPr>
                <p:spPr>
                  <a:xfrm rot="20400000">
                    <a:off x="1266480" y="1818360"/>
                    <a:ext cx="55440" cy="4428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2" name="Group 12"/>
                <p:cNvGrpSpPr/>
                <p:nvPr/>
              </p:nvGrpSpPr>
              <p:grpSpPr>
                <a:xfrm>
                  <a:off x="686160" y="1443240"/>
                  <a:ext cx="411840" cy="504720"/>
                  <a:chOff x="686160" y="1443240"/>
                  <a:chExt cx="411840" cy="504720"/>
                </a:xfrm>
              </p:grpSpPr>
              <p:sp>
                <p:nvSpPr>
                  <p:cNvPr id="53" name="Oval 13"/>
                  <p:cNvSpPr/>
                  <p:nvPr/>
                </p:nvSpPr>
                <p:spPr>
                  <a:xfrm rot="300000">
                    <a:off x="830160" y="1445040"/>
                    <a:ext cx="52560" cy="234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" name="Oval 14"/>
                  <p:cNvSpPr/>
                  <p:nvPr/>
                </p:nvSpPr>
                <p:spPr>
                  <a:xfrm rot="300000">
                    <a:off x="847080" y="1707120"/>
                    <a:ext cx="54720" cy="23868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" name="Oval 15"/>
                  <p:cNvSpPr/>
                  <p:nvPr/>
                </p:nvSpPr>
                <p:spPr>
                  <a:xfrm rot="3000000">
                    <a:off x="952560" y="1500840"/>
                    <a:ext cx="55440" cy="2599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" name="Oval 16"/>
                  <p:cNvSpPr/>
                  <p:nvPr/>
                </p:nvSpPr>
                <p:spPr>
                  <a:xfrm rot="2100000">
                    <a:off x="748800" y="1668240"/>
                    <a:ext cx="52560" cy="23508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Oval 17"/>
                  <p:cNvSpPr/>
                  <p:nvPr/>
                </p:nvSpPr>
                <p:spPr>
                  <a:xfrm rot="1200000">
                    <a:off x="841320" y="1672560"/>
                    <a:ext cx="54720" cy="43560"/>
                  </a:xfrm>
                  <a:prstGeom prst="ellipse">
                    <a:avLst/>
                  </a:pr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58" name="Group 432"/>
              <p:cNvGrpSpPr/>
              <p:nvPr/>
            </p:nvGrpSpPr>
            <p:grpSpPr>
              <a:xfrm>
                <a:off x="1983960" y="1034640"/>
                <a:ext cx="1619280" cy="1685880"/>
                <a:chOff x="1983960" y="1034640"/>
                <a:chExt cx="1619280" cy="1685880"/>
              </a:xfrm>
            </p:grpSpPr>
            <p:sp>
              <p:nvSpPr>
                <p:cNvPr id="59" name="Oval 19"/>
                <p:cNvSpPr/>
                <p:nvPr/>
              </p:nvSpPr>
              <p:spPr>
                <a:xfrm>
                  <a:off x="1983960" y="1034640"/>
                  <a:ext cx="161928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0" name="Group 20"/>
                <p:cNvGrpSpPr/>
                <p:nvPr/>
              </p:nvGrpSpPr>
              <p:grpSpPr>
                <a:xfrm>
                  <a:off x="2768040" y="1598400"/>
                  <a:ext cx="285120" cy="484200"/>
                  <a:chOff x="2768040" y="1598400"/>
                  <a:chExt cx="285120" cy="484200"/>
                </a:xfrm>
              </p:grpSpPr>
              <p:sp>
                <p:nvSpPr>
                  <p:cNvPr id="61" name="Oval 21"/>
                  <p:cNvSpPr/>
                  <p:nvPr/>
                </p:nvSpPr>
                <p:spPr>
                  <a:xfrm rot="20700000">
                    <a:off x="2797200" y="160128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Oval 22"/>
                  <p:cNvSpPr/>
                  <p:nvPr/>
                </p:nvSpPr>
                <p:spPr>
                  <a:xfrm rot="20700000">
                    <a:off x="2904480" y="1842480"/>
                    <a:ext cx="54000" cy="2368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Oval 23"/>
                  <p:cNvSpPr/>
                  <p:nvPr/>
                </p:nvSpPr>
                <p:spPr>
                  <a:xfrm rot="1800000">
                    <a:off x="2936520" y="1610280"/>
                    <a:ext cx="55440" cy="2595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Oval 24"/>
                  <p:cNvSpPr/>
                  <p:nvPr/>
                </p:nvSpPr>
                <p:spPr>
                  <a:xfrm rot="900000">
                    <a:off x="2797200" y="183816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Oval 25"/>
                  <p:cNvSpPr/>
                  <p:nvPr/>
                </p:nvSpPr>
                <p:spPr>
                  <a:xfrm>
                    <a:off x="2853720" y="1816200"/>
                    <a:ext cx="55440" cy="4428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6" name="Group 26"/>
                <p:cNvGrpSpPr/>
                <p:nvPr/>
              </p:nvGrpSpPr>
              <p:grpSpPr>
                <a:xfrm>
                  <a:off x="2572200" y="1579320"/>
                  <a:ext cx="285480" cy="483840"/>
                  <a:chOff x="2572200" y="1579320"/>
                  <a:chExt cx="285480" cy="483840"/>
                </a:xfrm>
              </p:grpSpPr>
              <p:sp>
                <p:nvSpPr>
                  <p:cNvPr id="67" name="Oval 27"/>
                  <p:cNvSpPr/>
                  <p:nvPr/>
                </p:nvSpPr>
                <p:spPr>
                  <a:xfrm rot="20700000">
                    <a:off x="2601360" y="1581840"/>
                    <a:ext cx="52920" cy="2343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Oval 28"/>
                  <p:cNvSpPr/>
                  <p:nvPr/>
                </p:nvSpPr>
                <p:spPr>
                  <a:xfrm rot="20700000">
                    <a:off x="2709000" y="1821600"/>
                    <a:ext cx="55440" cy="2383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Oval 29"/>
                  <p:cNvSpPr/>
                  <p:nvPr/>
                </p:nvSpPr>
                <p:spPr>
                  <a:xfrm rot="1800000">
                    <a:off x="2740680" y="1590840"/>
                    <a:ext cx="55800" cy="2599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Oval 30"/>
                  <p:cNvSpPr/>
                  <p:nvPr/>
                </p:nvSpPr>
                <p:spPr>
                  <a:xfrm rot="900000">
                    <a:off x="2601720" y="1819800"/>
                    <a:ext cx="52920" cy="234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" name="Oval 31"/>
                  <p:cNvSpPr/>
                  <p:nvPr/>
                </p:nvSpPr>
                <p:spPr>
                  <a:xfrm>
                    <a:off x="2657880" y="1797480"/>
                    <a:ext cx="55440" cy="43560"/>
                  </a:xfrm>
                  <a:prstGeom prst="ellipse">
                    <a:avLst/>
                  </a:pr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2" name="Group 53"/>
                <p:cNvGrpSpPr/>
                <p:nvPr/>
              </p:nvGrpSpPr>
              <p:grpSpPr>
                <a:xfrm>
                  <a:off x="3214080" y="1682280"/>
                  <a:ext cx="260280" cy="324000"/>
                  <a:chOff x="3214080" y="1682280"/>
                  <a:chExt cx="260280" cy="324000"/>
                </a:xfrm>
              </p:grpSpPr>
              <p:sp>
                <p:nvSpPr>
                  <p:cNvPr id="73" name="Line 47"/>
                  <p:cNvSpPr/>
                  <p:nvPr/>
                </p:nvSpPr>
                <p:spPr>
                  <a:xfrm flipH="1" flipV="1">
                    <a:off x="3408480" y="1682280"/>
                    <a:ext cx="65880" cy="65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Line 48"/>
                  <p:cNvSpPr/>
                  <p:nvPr/>
                </p:nvSpPr>
                <p:spPr>
                  <a:xfrm flipH="1">
                    <a:off x="3408480" y="1942200"/>
                    <a:ext cx="65880" cy="64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280" bIns="17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Line 49"/>
                  <p:cNvSpPr/>
                  <p:nvPr/>
                </p:nvSpPr>
                <p:spPr>
                  <a:xfrm flipH="1">
                    <a:off x="3214080" y="1846080"/>
                    <a:ext cx="260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6" name="Group 54"/>
                <p:cNvGrpSpPr/>
                <p:nvPr/>
              </p:nvGrpSpPr>
              <p:grpSpPr>
                <a:xfrm>
                  <a:off x="2049480" y="1682280"/>
                  <a:ext cx="271080" cy="331920"/>
                  <a:chOff x="2049480" y="1682280"/>
                  <a:chExt cx="271080" cy="331920"/>
                </a:xfrm>
              </p:grpSpPr>
              <p:sp>
                <p:nvSpPr>
                  <p:cNvPr id="77" name="Line 50"/>
                  <p:cNvSpPr/>
                  <p:nvPr/>
                </p:nvSpPr>
                <p:spPr>
                  <a:xfrm flipH="1">
                    <a:off x="2060640" y="1843200"/>
                    <a:ext cx="259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Line 51"/>
                  <p:cNvSpPr/>
                  <p:nvPr/>
                </p:nvSpPr>
                <p:spPr>
                  <a:xfrm flipH="1" flipV="1">
                    <a:off x="2049480" y="1932840"/>
                    <a:ext cx="106920" cy="81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Line 52"/>
                  <p:cNvSpPr/>
                  <p:nvPr/>
                </p:nvSpPr>
                <p:spPr>
                  <a:xfrm flipH="1">
                    <a:off x="2062080" y="1682280"/>
                    <a:ext cx="102960" cy="65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80" name="Oval 130"/>
              <p:cNvSpPr/>
              <p:nvPr/>
            </p:nvSpPr>
            <p:spPr>
              <a:xfrm>
                <a:off x="7188120" y="1126800"/>
                <a:ext cx="1619280" cy="16858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Oval 146"/>
              <p:cNvSpPr/>
              <p:nvPr/>
            </p:nvSpPr>
            <p:spPr>
              <a:xfrm>
                <a:off x="7251840" y="1331640"/>
                <a:ext cx="777960" cy="77616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Oval 145"/>
              <p:cNvSpPr/>
              <p:nvPr/>
            </p:nvSpPr>
            <p:spPr>
              <a:xfrm>
                <a:off x="7351920" y="1923840"/>
                <a:ext cx="777960" cy="777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Oval 143"/>
              <p:cNvSpPr/>
              <p:nvPr/>
            </p:nvSpPr>
            <p:spPr>
              <a:xfrm>
                <a:off x="7847280" y="1215720"/>
                <a:ext cx="776160" cy="7761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Oval 150"/>
              <p:cNvSpPr/>
              <p:nvPr/>
            </p:nvSpPr>
            <p:spPr>
              <a:xfrm>
                <a:off x="8031240" y="1255320"/>
                <a:ext cx="484200" cy="50796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Oval 154"/>
              <p:cNvSpPr/>
              <p:nvPr/>
            </p:nvSpPr>
            <p:spPr>
              <a:xfrm>
                <a:off x="7272360" y="1385640"/>
                <a:ext cx="583920" cy="5284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6" name="Group 156"/>
              <p:cNvGrpSpPr/>
              <p:nvPr/>
            </p:nvGrpSpPr>
            <p:grpSpPr>
              <a:xfrm>
                <a:off x="8130600" y="1290600"/>
                <a:ext cx="308880" cy="394920"/>
                <a:chOff x="8130600" y="1290600"/>
                <a:chExt cx="308880" cy="394920"/>
              </a:xfrm>
            </p:grpSpPr>
            <p:sp>
              <p:nvSpPr>
                <p:cNvPr id="87" name="Oval 157"/>
                <p:cNvSpPr/>
                <p:nvPr/>
              </p:nvSpPr>
              <p:spPr>
                <a:xfrm rot="18000000">
                  <a:off x="8295840" y="1483200"/>
                  <a:ext cx="54000" cy="23796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" name="Oval 158"/>
                <p:cNvSpPr/>
                <p:nvPr/>
              </p:nvSpPr>
              <p:spPr>
                <a:xfrm rot="20700000">
                  <a:off x="8163000" y="1293120"/>
                  <a:ext cx="55440" cy="25884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9" name="Oval 162"/>
              <p:cNvSpPr/>
              <p:nvPr/>
            </p:nvSpPr>
            <p:spPr>
              <a:xfrm>
                <a:off x="7423200" y="2128680"/>
                <a:ext cx="581040" cy="5191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0" name="Group 163"/>
              <p:cNvGrpSpPr/>
              <p:nvPr/>
            </p:nvGrpSpPr>
            <p:grpSpPr>
              <a:xfrm>
                <a:off x="7271640" y="1427400"/>
                <a:ext cx="394920" cy="309600"/>
                <a:chOff x="7271640" y="1427400"/>
                <a:chExt cx="394920" cy="309600"/>
              </a:xfrm>
            </p:grpSpPr>
            <p:sp>
              <p:nvSpPr>
                <p:cNvPr id="91" name="Oval 164"/>
                <p:cNvSpPr/>
                <p:nvPr/>
              </p:nvSpPr>
              <p:spPr>
                <a:xfrm rot="1800000">
                  <a:off x="7327440" y="1500840"/>
                  <a:ext cx="53640" cy="23832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" name="Oval 165"/>
                <p:cNvSpPr/>
                <p:nvPr/>
              </p:nvSpPr>
              <p:spPr>
                <a:xfrm rot="4500000">
                  <a:off x="7506360" y="1357920"/>
                  <a:ext cx="55440" cy="25920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3" name="Oval 144"/>
              <p:cNvSpPr/>
              <p:nvPr/>
            </p:nvSpPr>
            <p:spPr>
              <a:xfrm>
                <a:off x="7985160" y="1779120"/>
                <a:ext cx="776160" cy="777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Oval 155"/>
              <p:cNvSpPr/>
              <p:nvPr/>
            </p:nvSpPr>
            <p:spPr>
              <a:xfrm>
                <a:off x="8159760" y="1968120"/>
                <a:ext cx="583920" cy="5191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5" name="Group 168"/>
              <p:cNvGrpSpPr/>
              <p:nvPr/>
            </p:nvGrpSpPr>
            <p:grpSpPr>
              <a:xfrm>
                <a:off x="208800" y="4448160"/>
                <a:ext cx="1619280" cy="1685880"/>
                <a:chOff x="208800" y="4448160"/>
                <a:chExt cx="1619280" cy="1685880"/>
              </a:xfrm>
            </p:grpSpPr>
            <p:sp>
              <p:nvSpPr>
                <p:cNvPr id="96" name="Oval 169"/>
                <p:cNvSpPr/>
                <p:nvPr/>
              </p:nvSpPr>
              <p:spPr>
                <a:xfrm>
                  <a:off x="208800" y="4448160"/>
                  <a:ext cx="161928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97" name="Group 170"/>
                <p:cNvGrpSpPr/>
                <p:nvPr/>
              </p:nvGrpSpPr>
              <p:grpSpPr>
                <a:xfrm>
                  <a:off x="1053000" y="5028120"/>
                  <a:ext cx="363240" cy="501840"/>
                  <a:chOff x="1053000" y="5028120"/>
                  <a:chExt cx="363240" cy="501840"/>
                </a:xfrm>
              </p:grpSpPr>
              <p:sp>
                <p:nvSpPr>
                  <p:cNvPr id="98" name="Oval 171"/>
                  <p:cNvSpPr/>
                  <p:nvPr/>
                </p:nvSpPr>
                <p:spPr>
                  <a:xfrm rot="19500000">
                    <a:off x="1115280" y="507096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9" name="Oval 172"/>
                  <p:cNvSpPr/>
                  <p:nvPr/>
                </p:nvSpPr>
                <p:spPr>
                  <a:xfrm rot="19500000">
                    <a:off x="1299240" y="5260680"/>
                    <a:ext cx="54000" cy="2368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Oval 173"/>
                  <p:cNvSpPr/>
                  <p:nvPr/>
                </p:nvSpPr>
                <p:spPr>
                  <a:xfrm rot="600000">
                    <a:off x="1253880" y="5030640"/>
                    <a:ext cx="55440" cy="2595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Oval 174"/>
                  <p:cNvSpPr/>
                  <p:nvPr/>
                </p:nvSpPr>
                <p:spPr>
                  <a:xfrm rot="21300000">
                    <a:off x="1196280" y="529380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2" name="Oval 175"/>
                  <p:cNvSpPr/>
                  <p:nvPr/>
                </p:nvSpPr>
                <p:spPr>
                  <a:xfrm rot="20400000">
                    <a:off x="1209240" y="5258880"/>
                    <a:ext cx="55440" cy="4428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03" name="Group 176"/>
                <p:cNvGrpSpPr/>
                <p:nvPr/>
              </p:nvGrpSpPr>
              <p:grpSpPr>
                <a:xfrm>
                  <a:off x="628920" y="4883760"/>
                  <a:ext cx="411840" cy="504720"/>
                  <a:chOff x="628920" y="4883760"/>
                  <a:chExt cx="411840" cy="504720"/>
                </a:xfrm>
              </p:grpSpPr>
              <p:sp>
                <p:nvSpPr>
                  <p:cNvPr id="104" name="Oval 177"/>
                  <p:cNvSpPr/>
                  <p:nvPr/>
                </p:nvSpPr>
                <p:spPr>
                  <a:xfrm rot="300000">
                    <a:off x="772920" y="4885560"/>
                    <a:ext cx="52560" cy="234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5" name="Oval 178"/>
                  <p:cNvSpPr/>
                  <p:nvPr/>
                </p:nvSpPr>
                <p:spPr>
                  <a:xfrm rot="300000">
                    <a:off x="789840" y="5147640"/>
                    <a:ext cx="54720" cy="23868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6" name="Oval 179"/>
                  <p:cNvSpPr/>
                  <p:nvPr/>
                </p:nvSpPr>
                <p:spPr>
                  <a:xfrm rot="3000000">
                    <a:off x="895320" y="4941360"/>
                    <a:ext cx="55440" cy="2599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7" name="Oval 180"/>
                  <p:cNvSpPr/>
                  <p:nvPr/>
                </p:nvSpPr>
                <p:spPr>
                  <a:xfrm rot="2100000">
                    <a:off x="691560" y="5108760"/>
                    <a:ext cx="52560" cy="23508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8" name="Oval 181"/>
                  <p:cNvSpPr/>
                  <p:nvPr/>
                </p:nvSpPr>
                <p:spPr>
                  <a:xfrm rot="1200000">
                    <a:off x="784080" y="5113080"/>
                    <a:ext cx="54720" cy="43560"/>
                  </a:xfrm>
                  <a:prstGeom prst="ellipse">
                    <a:avLst/>
                  </a:pr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109" name="Group 431"/>
              <p:cNvGrpSpPr/>
              <p:nvPr/>
            </p:nvGrpSpPr>
            <p:grpSpPr>
              <a:xfrm>
                <a:off x="1926720" y="4513320"/>
                <a:ext cx="1619280" cy="1685880"/>
                <a:chOff x="1926720" y="4513320"/>
                <a:chExt cx="1619280" cy="1685880"/>
              </a:xfrm>
            </p:grpSpPr>
            <p:sp>
              <p:nvSpPr>
                <p:cNvPr id="110" name="Oval 183"/>
                <p:cNvSpPr/>
                <p:nvPr/>
              </p:nvSpPr>
              <p:spPr>
                <a:xfrm>
                  <a:off x="1926720" y="4513320"/>
                  <a:ext cx="161928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11" name="Group 184"/>
                <p:cNvGrpSpPr/>
                <p:nvPr/>
              </p:nvGrpSpPr>
              <p:grpSpPr>
                <a:xfrm>
                  <a:off x="2710800" y="5067360"/>
                  <a:ext cx="285120" cy="484200"/>
                  <a:chOff x="2710800" y="5067360"/>
                  <a:chExt cx="285120" cy="484200"/>
                </a:xfrm>
              </p:grpSpPr>
              <p:sp>
                <p:nvSpPr>
                  <p:cNvPr id="112" name="Oval 185"/>
                  <p:cNvSpPr/>
                  <p:nvPr/>
                </p:nvSpPr>
                <p:spPr>
                  <a:xfrm rot="20700000">
                    <a:off x="2739960" y="507024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Oval 186"/>
                  <p:cNvSpPr/>
                  <p:nvPr/>
                </p:nvSpPr>
                <p:spPr>
                  <a:xfrm rot="20700000">
                    <a:off x="2847240" y="5311440"/>
                    <a:ext cx="54000" cy="2368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4" name="Oval 187"/>
                  <p:cNvSpPr/>
                  <p:nvPr/>
                </p:nvSpPr>
                <p:spPr>
                  <a:xfrm rot="1800000">
                    <a:off x="2879280" y="5079240"/>
                    <a:ext cx="55440" cy="2595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5" name="Oval 188"/>
                  <p:cNvSpPr/>
                  <p:nvPr/>
                </p:nvSpPr>
                <p:spPr>
                  <a:xfrm rot="900000">
                    <a:off x="2739960" y="530712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6" name="Oval 189"/>
                  <p:cNvSpPr/>
                  <p:nvPr/>
                </p:nvSpPr>
                <p:spPr>
                  <a:xfrm>
                    <a:off x="2796480" y="5285160"/>
                    <a:ext cx="55440" cy="4428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17" name="Group 190"/>
                <p:cNvGrpSpPr/>
                <p:nvPr/>
              </p:nvGrpSpPr>
              <p:grpSpPr>
                <a:xfrm>
                  <a:off x="2514960" y="5058000"/>
                  <a:ext cx="285480" cy="483840"/>
                  <a:chOff x="2514960" y="5058000"/>
                  <a:chExt cx="285480" cy="483840"/>
                </a:xfrm>
              </p:grpSpPr>
              <p:sp>
                <p:nvSpPr>
                  <p:cNvPr id="118" name="Oval 191"/>
                  <p:cNvSpPr/>
                  <p:nvPr/>
                </p:nvSpPr>
                <p:spPr>
                  <a:xfrm rot="20700000">
                    <a:off x="2544120" y="5060520"/>
                    <a:ext cx="52920" cy="2343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9" name="Oval 192"/>
                  <p:cNvSpPr/>
                  <p:nvPr/>
                </p:nvSpPr>
                <p:spPr>
                  <a:xfrm rot="20700000">
                    <a:off x="2651760" y="5300280"/>
                    <a:ext cx="55440" cy="2383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0" name="Oval 193"/>
                  <p:cNvSpPr/>
                  <p:nvPr/>
                </p:nvSpPr>
                <p:spPr>
                  <a:xfrm rot="1800000">
                    <a:off x="2683440" y="5069520"/>
                    <a:ext cx="55800" cy="2599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1" name="Oval 194"/>
                  <p:cNvSpPr/>
                  <p:nvPr/>
                </p:nvSpPr>
                <p:spPr>
                  <a:xfrm rot="900000">
                    <a:off x="2544480" y="5298480"/>
                    <a:ext cx="52920" cy="234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2" name="Oval 195"/>
                  <p:cNvSpPr/>
                  <p:nvPr/>
                </p:nvSpPr>
                <p:spPr>
                  <a:xfrm>
                    <a:off x="2600640" y="5276160"/>
                    <a:ext cx="55440" cy="43560"/>
                  </a:xfrm>
                  <a:prstGeom prst="ellipse">
                    <a:avLst/>
                  </a:pr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5480" bIns="-154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3" name="Group 196"/>
                <p:cNvGrpSpPr/>
                <p:nvPr/>
              </p:nvGrpSpPr>
              <p:grpSpPr>
                <a:xfrm>
                  <a:off x="3156840" y="5160960"/>
                  <a:ext cx="260280" cy="324000"/>
                  <a:chOff x="3156840" y="5160960"/>
                  <a:chExt cx="260280" cy="324000"/>
                </a:xfrm>
              </p:grpSpPr>
              <p:sp>
                <p:nvSpPr>
                  <p:cNvPr id="124" name="Line 197"/>
                  <p:cNvSpPr/>
                  <p:nvPr/>
                </p:nvSpPr>
                <p:spPr>
                  <a:xfrm flipH="1" flipV="1">
                    <a:off x="3351240" y="5160960"/>
                    <a:ext cx="65880" cy="65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5" name="Line 198"/>
                  <p:cNvSpPr/>
                  <p:nvPr/>
                </p:nvSpPr>
                <p:spPr>
                  <a:xfrm flipH="1">
                    <a:off x="3351240" y="5420880"/>
                    <a:ext cx="65880" cy="64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280" bIns="17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6" name="Line 199"/>
                  <p:cNvSpPr/>
                  <p:nvPr/>
                </p:nvSpPr>
                <p:spPr>
                  <a:xfrm flipH="1">
                    <a:off x="3156840" y="5324760"/>
                    <a:ext cx="260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7" name="Group 200"/>
                <p:cNvGrpSpPr/>
                <p:nvPr/>
              </p:nvGrpSpPr>
              <p:grpSpPr>
                <a:xfrm>
                  <a:off x="1992240" y="5160960"/>
                  <a:ext cx="271080" cy="331920"/>
                  <a:chOff x="1992240" y="5160960"/>
                  <a:chExt cx="271080" cy="331920"/>
                </a:xfrm>
              </p:grpSpPr>
              <p:sp>
                <p:nvSpPr>
                  <p:cNvPr id="128" name="Line 201"/>
                  <p:cNvSpPr/>
                  <p:nvPr/>
                </p:nvSpPr>
                <p:spPr>
                  <a:xfrm flipH="1">
                    <a:off x="2003400" y="5321880"/>
                    <a:ext cx="259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9" name="Line 202"/>
                  <p:cNvSpPr/>
                  <p:nvPr/>
                </p:nvSpPr>
                <p:spPr>
                  <a:xfrm flipH="1" flipV="1">
                    <a:off x="1992240" y="5411520"/>
                    <a:ext cx="106920" cy="81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0" name="Line 203"/>
                  <p:cNvSpPr/>
                  <p:nvPr/>
                </p:nvSpPr>
                <p:spPr>
                  <a:xfrm flipH="1">
                    <a:off x="2004840" y="5160960"/>
                    <a:ext cx="102960" cy="65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131" name="Oval 205"/>
              <p:cNvSpPr/>
              <p:nvPr/>
            </p:nvSpPr>
            <p:spPr>
              <a:xfrm>
                <a:off x="3661920" y="4557600"/>
                <a:ext cx="1619280" cy="16858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32" name="Group 212"/>
              <p:cNvGrpSpPr/>
              <p:nvPr/>
            </p:nvGrpSpPr>
            <p:grpSpPr>
              <a:xfrm>
                <a:off x="4413960" y="4624560"/>
                <a:ext cx="252000" cy="253440"/>
                <a:chOff x="4413960" y="4624560"/>
                <a:chExt cx="252000" cy="253440"/>
              </a:xfrm>
            </p:grpSpPr>
            <p:sp>
              <p:nvSpPr>
                <p:cNvPr id="133" name="Line 213"/>
                <p:cNvSpPr/>
                <p:nvPr/>
              </p:nvSpPr>
              <p:spPr>
                <a:xfrm flipH="1">
                  <a:off x="4435560" y="4624560"/>
                  <a:ext cx="92880" cy="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4" name="Line 214"/>
                <p:cNvSpPr/>
                <p:nvPr/>
              </p:nvSpPr>
              <p:spPr>
                <a:xfrm flipH="1">
                  <a:off x="4664160" y="4761720"/>
                  <a:ext cx="1800" cy="9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000" bIns="45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5" name="Line 215"/>
                <p:cNvSpPr/>
                <p:nvPr/>
              </p:nvSpPr>
              <p:spPr>
                <a:xfrm flipH="1">
                  <a:off x="4413960" y="4694040"/>
                  <a:ext cx="184320" cy="183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36" name="Group 216"/>
              <p:cNvGrpSpPr/>
              <p:nvPr/>
            </p:nvGrpSpPr>
            <p:grpSpPr>
              <a:xfrm>
                <a:off x="3770280" y="5267880"/>
                <a:ext cx="254520" cy="258120"/>
                <a:chOff x="3770280" y="5267880"/>
                <a:chExt cx="254520" cy="258120"/>
              </a:xfrm>
            </p:grpSpPr>
            <p:sp>
              <p:nvSpPr>
                <p:cNvPr id="137" name="Line 217"/>
                <p:cNvSpPr/>
                <p:nvPr/>
              </p:nvSpPr>
              <p:spPr>
                <a:xfrm flipH="1">
                  <a:off x="3836880" y="5271480"/>
                  <a:ext cx="183600" cy="183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Line 218"/>
                <p:cNvSpPr/>
                <p:nvPr/>
              </p:nvSpPr>
              <p:spPr>
                <a:xfrm flipH="1">
                  <a:off x="3891960" y="5507640"/>
                  <a:ext cx="132840" cy="18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Line 219"/>
                <p:cNvSpPr/>
                <p:nvPr/>
              </p:nvSpPr>
              <p:spPr>
                <a:xfrm flipH="1">
                  <a:off x="3770280" y="5267880"/>
                  <a:ext cx="26640" cy="118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0" name="Group 234"/>
              <p:cNvGrpSpPr/>
              <p:nvPr/>
            </p:nvGrpSpPr>
            <p:grpSpPr>
              <a:xfrm>
                <a:off x="4847400" y="5032440"/>
                <a:ext cx="252000" cy="253440"/>
                <a:chOff x="4847400" y="5032440"/>
                <a:chExt cx="252000" cy="253440"/>
              </a:xfrm>
            </p:grpSpPr>
            <p:sp>
              <p:nvSpPr>
                <p:cNvPr id="141" name="Line 235"/>
                <p:cNvSpPr/>
                <p:nvPr/>
              </p:nvSpPr>
              <p:spPr>
                <a:xfrm flipH="1">
                  <a:off x="4869000" y="5032440"/>
                  <a:ext cx="92880" cy="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2" name="Line 236"/>
                <p:cNvSpPr/>
                <p:nvPr/>
              </p:nvSpPr>
              <p:spPr>
                <a:xfrm flipH="1">
                  <a:off x="5097600" y="5169600"/>
                  <a:ext cx="1800" cy="9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000" bIns="45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3" name="Line 237"/>
                <p:cNvSpPr/>
                <p:nvPr/>
              </p:nvSpPr>
              <p:spPr>
                <a:xfrm flipH="1">
                  <a:off x="4847400" y="5101920"/>
                  <a:ext cx="184320" cy="183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4" name="Group 238"/>
              <p:cNvGrpSpPr/>
              <p:nvPr/>
            </p:nvGrpSpPr>
            <p:grpSpPr>
              <a:xfrm>
                <a:off x="4158000" y="5717520"/>
                <a:ext cx="255240" cy="258840"/>
                <a:chOff x="4158000" y="5717520"/>
                <a:chExt cx="255240" cy="258840"/>
              </a:xfrm>
            </p:grpSpPr>
            <p:sp>
              <p:nvSpPr>
                <p:cNvPr id="145" name="Line 239"/>
                <p:cNvSpPr/>
                <p:nvPr/>
              </p:nvSpPr>
              <p:spPr>
                <a:xfrm flipH="1">
                  <a:off x="4224960" y="5722560"/>
                  <a:ext cx="182520" cy="182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6" name="Line 240"/>
                <p:cNvSpPr/>
                <p:nvPr/>
              </p:nvSpPr>
              <p:spPr>
                <a:xfrm flipH="1">
                  <a:off x="4280400" y="5959080"/>
                  <a:ext cx="132840" cy="17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7" name="Line 241"/>
                <p:cNvSpPr/>
                <p:nvPr/>
              </p:nvSpPr>
              <p:spPr>
                <a:xfrm flipH="1">
                  <a:off x="4158000" y="5717520"/>
                  <a:ext cx="25920" cy="118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48" name="Oval 244"/>
              <p:cNvSpPr/>
              <p:nvPr/>
            </p:nvSpPr>
            <p:spPr>
              <a:xfrm>
                <a:off x="5394240" y="4513320"/>
                <a:ext cx="1619280" cy="16858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49" name="Group 245"/>
              <p:cNvGrpSpPr/>
              <p:nvPr/>
            </p:nvGrpSpPr>
            <p:grpSpPr>
              <a:xfrm>
                <a:off x="5849280" y="5752800"/>
                <a:ext cx="309600" cy="396360"/>
                <a:chOff x="5849280" y="5752800"/>
                <a:chExt cx="309600" cy="396360"/>
              </a:xfrm>
            </p:grpSpPr>
            <p:sp>
              <p:nvSpPr>
                <p:cNvPr id="150" name="Oval 246"/>
                <p:cNvSpPr/>
                <p:nvPr/>
              </p:nvSpPr>
              <p:spPr>
                <a:xfrm rot="7200000">
                  <a:off x="5938560" y="5716440"/>
                  <a:ext cx="54000" cy="23832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1" name="Oval 247"/>
                <p:cNvSpPr/>
                <p:nvPr/>
              </p:nvSpPr>
              <p:spPr>
                <a:xfrm rot="9900000">
                  <a:off x="6070320" y="5885640"/>
                  <a:ext cx="55440" cy="26064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52" name="Group 251"/>
              <p:cNvGrpSpPr/>
              <p:nvPr/>
            </p:nvGrpSpPr>
            <p:grpSpPr>
              <a:xfrm>
                <a:off x="6333120" y="4638960"/>
                <a:ext cx="309600" cy="396360"/>
                <a:chOff x="6333120" y="4638960"/>
                <a:chExt cx="309600" cy="396360"/>
              </a:xfrm>
            </p:grpSpPr>
            <p:sp>
              <p:nvSpPr>
                <p:cNvPr id="153" name="Oval 252"/>
                <p:cNvSpPr/>
                <p:nvPr/>
              </p:nvSpPr>
              <p:spPr>
                <a:xfrm rot="18000000">
                  <a:off x="6498720" y="4833000"/>
                  <a:ext cx="54360" cy="23796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4" name="Oval 253"/>
                <p:cNvSpPr/>
                <p:nvPr/>
              </p:nvSpPr>
              <p:spPr>
                <a:xfrm rot="20700000">
                  <a:off x="6365520" y="4641480"/>
                  <a:ext cx="55440" cy="26028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55" name="Oval 260"/>
              <p:cNvSpPr/>
              <p:nvPr/>
            </p:nvSpPr>
            <p:spPr>
              <a:xfrm rot="2700000">
                <a:off x="5288040" y="5455440"/>
                <a:ext cx="1166760" cy="5173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Oval 261"/>
              <p:cNvSpPr/>
              <p:nvPr/>
            </p:nvSpPr>
            <p:spPr>
              <a:xfrm rot="2700000">
                <a:off x="5956560" y="4742640"/>
                <a:ext cx="1166760" cy="5173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Oval 262"/>
              <p:cNvSpPr/>
              <p:nvPr/>
            </p:nvSpPr>
            <p:spPr>
              <a:xfrm>
                <a:off x="7110360" y="4557600"/>
                <a:ext cx="1619280" cy="16858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Oval 263"/>
              <p:cNvSpPr/>
              <p:nvPr/>
            </p:nvSpPr>
            <p:spPr>
              <a:xfrm rot="18900000">
                <a:off x="7812000" y="4698720"/>
                <a:ext cx="711000" cy="71280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Oval 266"/>
              <p:cNvSpPr/>
              <p:nvPr/>
            </p:nvSpPr>
            <p:spPr>
              <a:xfrm rot="18900000">
                <a:off x="7267680" y="5365800"/>
                <a:ext cx="712800" cy="71280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prstDash val="dash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Oval 268"/>
              <p:cNvSpPr/>
              <p:nvPr/>
            </p:nvSpPr>
            <p:spPr>
              <a:xfrm rot="18900000">
                <a:off x="7245360" y="5167080"/>
                <a:ext cx="777960" cy="11239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Oval 269"/>
              <p:cNvSpPr/>
              <p:nvPr/>
            </p:nvSpPr>
            <p:spPr>
              <a:xfrm rot="18900000">
                <a:off x="7780320" y="4522320"/>
                <a:ext cx="776160" cy="111600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62" name="Group 270"/>
              <p:cNvGrpSpPr/>
              <p:nvPr/>
            </p:nvGrpSpPr>
            <p:grpSpPr>
              <a:xfrm>
                <a:off x="7454160" y="5533560"/>
                <a:ext cx="309600" cy="394920"/>
                <a:chOff x="7454160" y="5533560"/>
                <a:chExt cx="309600" cy="394920"/>
              </a:xfrm>
            </p:grpSpPr>
            <p:sp>
              <p:nvSpPr>
                <p:cNvPr id="163" name="Oval 271"/>
                <p:cNvSpPr/>
                <p:nvPr/>
              </p:nvSpPr>
              <p:spPr>
                <a:xfrm rot="7200000">
                  <a:off x="7543800" y="5497200"/>
                  <a:ext cx="53640" cy="23832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4" name="Oval 272"/>
                <p:cNvSpPr/>
                <p:nvPr/>
              </p:nvSpPr>
              <p:spPr>
                <a:xfrm rot="9900000">
                  <a:off x="7675560" y="5666400"/>
                  <a:ext cx="55440" cy="25920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5" name="Group 276"/>
              <p:cNvGrpSpPr/>
              <p:nvPr/>
            </p:nvGrpSpPr>
            <p:grpSpPr>
              <a:xfrm>
                <a:off x="8037000" y="4824720"/>
                <a:ext cx="310320" cy="394920"/>
                <a:chOff x="8037000" y="4824720"/>
                <a:chExt cx="310320" cy="394920"/>
              </a:xfrm>
            </p:grpSpPr>
            <p:sp>
              <p:nvSpPr>
                <p:cNvPr id="166" name="Oval 277"/>
                <p:cNvSpPr/>
                <p:nvPr/>
              </p:nvSpPr>
              <p:spPr>
                <a:xfrm rot="18000000">
                  <a:off x="8203320" y="5016960"/>
                  <a:ext cx="54000" cy="23904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7" name="Oval 278"/>
                <p:cNvSpPr/>
                <p:nvPr/>
              </p:nvSpPr>
              <p:spPr>
                <a:xfrm rot="20700000">
                  <a:off x="8069400" y="4827240"/>
                  <a:ext cx="55800" cy="25884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68" name="Text Box 288"/>
              <p:cNvSpPr/>
              <p:nvPr/>
            </p:nvSpPr>
            <p:spPr>
              <a:xfrm>
                <a:off x="34920" y="188640"/>
                <a:ext cx="22197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Arial"/>
                  </a:rPr>
                  <a:t>a) Typical meiosis</a:t>
                </a: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Text Box 289"/>
              <p:cNvSpPr/>
              <p:nvPr/>
            </p:nvSpPr>
            <p:spPr>
              <a:xfrm>
                <a:off x="117000" y="3644640"/>
                <a:ext cx="233244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Arial"/>
                  </a:rPr>
                  <a:t>b) Parallel spindles</a:t>
                </a: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Text Box 290"/>
              <p:cNvSpPr/>
              <p:nvPr/>
            </p:nvSpPr>
            <p:spPr>
              <a:xfrm>
                <a:off x="2123640" y="4149720"/>
                <a:ext cx="1224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Meiosis I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Text Box 291"/>
              <p:cNvSpPr/>
              <p:nvPr/>
            </p:nvSpPr>
            <p:spPr>
              <a:xfrm>
                <a:off x="2180880" y="672840"/>
                <a:ext cx="1224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Meiosis I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Text Box 292"/>
              <p:cNvSpPr/>
              <p:nvPr/>
            </p:nvSpPr>
            <p:spPr>
              <a:xfrm>
                <a:off x="4643280" y="4149720"/>
                <a:ext cx="1224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Meiosis II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Text Box 293"/>
              <p:cNvSpPr/>
              <p:nvPr/>
            </p:nvSpPr>
            <p:spPr>
              <a:xfrm>
                <a:off x="4859280" y="691560"/>
                <a:ext cx="1224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Meiosis II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Text Box 294"/>
              <p:cNvSpPr/>
              <p:nvPr/>
            </p:nvSpPr>
            <p:spPr>
              <a:xfrm>
                <a:off x="6868440" y="4168800"/>
                <a:ext cx="2113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Dyad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 Box 295"/>
              <p:cNvSpPr/>
              <p:nvPr/>
            </p:nvSpPr>
            <p:spPr>
              <a:xfrm>
                <a:off x="7173720" y="721440"/>
                <a:ext cx="1754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Tetrad 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76" name="Group 441"/>
              <p:cNvGrpSpPr/>
              <p:nvPr/>
            </p:nvGrpSpPr>
            <p:grpSpPr>
              <a:xfrm>
                <a:off x="5460840" y="1125000"/>
                <a:ext cx="1620720" cy="1685880"/>
                <a:chOff x="5460840" y="1125000"/>
                <a:chExt cx="1620720" cy="1685880"/>
              </a:xfrm>
            </p:grpSpPr>
            <p:sp>
              <p:nvSpPr>
                <p:cNvPr id="177" name="Oval 121"/>
                <p:cNvSpPr/>
                <p:nvPr/>
              </p:nvSpPr>
              <p:spPr>
                <a:xfrm>
                  <a:off x="6278040" y="1254960"/>
                  <a:ext cx="583920" cy="51876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prstDash val="dash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8" name="Oval 104"/>
                <p:cNvSpPr/>
                <p:nvPr/>
              </p:nvSpPr>
              <p:spPr>
                <a:xfrm>
                  <a:off x="5460840" y="1125000"/>
                  <a:ext cx="162072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79" name="Group 112"/>
                <p:cNvGrpSpPr/>
                <p:nvPr/>
              </p:nvGrpSpPr>
              <p:grpSpPr>
                <a:xfrm>
                  <a:off x="5721840" y="1516320"/>
                  <a:ext cx="362880" cy="362520"/>
                  <a:chOff x="5721840" y="1516320"/>
                  <a:chExt cx="362880" cy="362520"/>
                </a:xfrm>
              </p:grpSpPr>
              <p:sp>
                <p:nvSpPr>
                  <p:cNvPr id="180" name="Oval 106"/>
                  <p:cNvSpPr/>
                  <p:nvPr/>
                </p:nvSpPr>
                <p:spPr>
                  <a:xfrm rot="1800000">
                    <a:off x="5977080" y="1513800"/>
                    <a:ext cx="52560" cy="23364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1" name="Oval 109"/>
                  <p:cNvSpPr/>
                  <p:nvPr/>
                </p:nvSpPr>
                <p:spPr>
                  <a:xfrm rot="3600000">
                    <a:off x="5810040" y="1680480"/>
                    <a:ext cx="52560" cy="23400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82" name="Group 119"/>
                <p:cNvGrpSpPr/>
                <p:nvPr/>
              </p:nvGrpSpPr>
              <p:grpSpPr>
                <a:xfrm>
                  <a:off x="6465960" y="1315440"/>
                  <a:ext cx="309600" cy="396360"/>
                  <a:chOff x="6465960" y="1315440"/>
                  <a:chExt cx="309600" cy="396360"/>
                </a:xfrm>
              </p:grpSpPr>
              <p:sp>
                <p:nvSpPr>
                  <p:cNvPr id="183" name="Oval 115"/>
                  <p:cNvSpPr/>
                  <p:nvPr/>
                </p:nvSpPr>
                <p:spPr>
                  <a:xfrm rot="18000000">
                    <a:off x="6631560" y="1509480"/>
                    <a:ext cx="54360" cy="2379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4" name="Oval 116"/>
                  <p:cNvSpPr/>
                  <p:nvPr/>
                </p:nvSpPr>
                <p:spPr>
                  <a:xfrm rot="20700000">
                    <a:off x="6498360" y="1317960"/>
                    <a:ext cx="55440" cy="26028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185" name="Oval 122"/>
                <p:cNvSpPr/>
                <p:nvPr/>
              </p:nvSpPr>
              <p:spPr>
                <a:xfrm>
                  <a:off x="5565240" y="2052000"/>
                  <a:ext cx="583920" cy="52812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prstDash val="dash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6" name="Oval 123"/>
                <p:cNvSpPr/>
                <p:nvPr/>
              </p:nvSpPr>
              <p:spPr>
                <a:xfrm>
                  <a:off x="6432120" y="2096280"/>
                  <a:ext cx="483840" cy="50760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prstDash val="dash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7" name="Oval 124"/>
                <p:cNvSpPr/>
                <p:nvPr/>
              </p:nvSpPr>
              <p:spPr>
                <a:xfrm>
                  <a:off x="5654160" y="1448640"/>
                  <a:ext cx="583920" cy="51876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prstDash val="dash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88" name="Group 374"/>
                <p:cNvGrpSpPr/>
                <p:nvPr/>
              </p:nvGrpSpPr>
              <p:grpSpPr>
                <a:xfrm>
                  <a:off x="6479640" y="2201760"/>
                  <a:ext cx="407160" cy="315360"/>
                  <a:chOff x="6479640" y="2201760"/>
                  <a:chExt cx="407160" cy="315360"/>
                </a:xfrm>
              </p:grpSpPr>
              <p:sp>
                <p:nvSpPr>
                  <p:cNvPr id="189" name="Oval 375"/>
                  <p:cNvSpPr/>
                  <p:nvPr/>
                </p:nvSpPr>
                <p:spPr>
                  <a:xfrm rot="1800000">
                    <a:off x="6536160" y="2276640"/>
                    <a:ext cx="56880" cy="2422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190" name="Group 376"/>
                  <p:cNvGrpSpPr/>
                  <p:nvPr/>
                </p:nvGrpSpPr>
                <p:grpSpPr>
                  <a:xfrm>
                    <a:off x="6614280" y="2201760"/>
                    <a:ext cx="272520" cy="121680"/>
                    <a:chOff x="6614280" y="2201760"/>
                    <a:chExt cx="272520" cy="121680"/>
                  </a:xfrm>
                </p:grpSpPr>
                <p:sp>
                  <p:nvSpPr>
                    <p:cNvPr id="191" name="Oval 377"/>
                    <p:cNvSpPr/>
                    <p:nvPr/>
                  </p:nvSpPr>
                  <p:spPr>
                    <a:xfrm rot="4500000">
                      <a:off x="6719760" y="2131560"/>
                      <a:ext cx="55800" cy="26172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92" name="Oval 378"/>
                    <p:cNvSpPr/>
                    <p:nvPr/>
                  </p:nvSpPr>
                  <p:spPr>
                    <a:xfrm rot="4500000">
                      <a:off x="6801480" y="2184840"/>
                      <a:ext cx="48600" cy="1130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33120" bIns="33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93" name="AutoShape 379"/>
                    <p:cNvSpPr/>
                    <p:nvPr/>
                  </p:nvSpPr>
                  <p:spPr>
                    <a:xfrm rot="4500000">
                      <a:off x="6762600" y="2218320"/>
                      <a:ext cx="48600" cy="64080"/>
                    </a:xfrm>
                    <a:custGeom>
                      <a:avLst/>
                      <a:gdLst>
                        <a:gd name="textAreaLeft" fmla="*/ 2160 w 48600"/>
                        <a:gd name="textAreaRight" fmla="*/ 46440 w 48600"/>
                        <a:gd name="textAreaTop" fmla="*/ 2160 h 64080"/>
                        <a:gd name="textAreaBottom" fmla="*/ 61920 h 64080"/>
                      </a:gdLst>
                      <a:ahLst/>
                      <a:rect l="textAreaLeft" t="textAreaTop" r="textAreaRight" b="textAreaBottom"/>
                      <a:pathLst>
                        <a:path w="21600" h="28429">
                          <a:moveTo>
                            <a:pt x="3600" y="0"/>
                          </a:moveTo>
                          <a:arcTo wR="3600" hR="3600" stAng="16200000" swAng="-5400000"/>
                          <a:lnTo>
                            <a:pt x="0" y="24829"/>
                          </a:lnTo>
                          <a:arcTo wR="3600" hR="3600" stAng="10800000" swAng="-5400000"/>
                          <a:lnTo>
                            <a:pt x="18000" y="28429"/>
                          </a:lnTo>
                          <a:arcTo wR="3600" hR="3600" stAng="5400000" swAng="-5400000"/>
                          <a:lnTo>
                            <a:pt x="21600" y="3600"/>
                          </a:lnTo>
                          <a:arcTo wR="3600" hR="3600" stAng="0" swAng="-5400000"/>
                          <a:close/>
                        </a:path>
                      </a:pathLst>
                    </a:custGeom>
                    <a:solidFill>
                      <a:srgbClr val="ff00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12960" bIns="129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194" name="Group 380"/>
                <p:cNvGrpSpPr/>
                <p:nvPr/>
              </p:nvGrpSpPr>
              <p:grpSpPr>
                <a:xfrm>
                  <a:off x="5632920" y="2203560"/>
                  <a:ext cx="383040" cy="302400"/>
                  <a:chOff x="5632920" y="2203560"/>
                  <a:chExt cx="383040" cy="302400"/>
                </a:xfrm>
              </p:grpSpPr>
              <p:sp>
                <p:nvSpPr>
                  <p:cNvPr id="195" name="Oval 381"/>
                  <p:cNvSpPr/>
                  <p:nvPr/>
                </p:nvSpPr>
                <p:spPr>
                  <a:xfrm flipH="1" rot="19800000">
                    <a:off x="5913000" y="2274840"/>
                    <a:ext cx="47520" cy="234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196" name="Group 382"/>
                  <p:cNvGrpSpPr/>
                  <p:nvPr/>
                </p:nvGrpSpPr>
                <p:grpSpPr>
                  <a:xfrm>
                    <a:off x="5632920" y="2203560"/>
                    <a:ext cx="262800" cy="114840"/>
                    <a:chOff x="5632920" y="2203560"/>
                    <a:chExt cx="262800" cy="114840"/>
                  </a:xfrm>
                </p:grpSpPr>
                <p:grpSp>
                  <p:nvGrpSpPr>
                    <p:cNvPr id="197" name="Group 383"/>
                    <p:cNvGrpSpPr/>
                    <p:nvPr/>
                  </p:nvGrpSpPr>
                  <p:grpSpPr>
                    <a:xfrm>
                      <a:off x="5632920" y="2203560"/>
                      <a:ext cx="262800" cy="114840"/>
                      <a:chOff x="5632920" y="2203560"/>
                      <a:chExt cx="262800" cy="114840"/>
                    </a:xfrm>
                  </p:grpSpPr>
                  <p:sp>
                    <p:nvSpPr>
                      <p:cNvPr id="198" name="Oval 384"/>
                      <p:cNvSpPr/>
                      <p:nvPr/>
                    </p:nvSpPr>
                    <p:spPr>
                      <a:xfrm flipH="1" rot="17100000">
                        <a:off x="5739120" y="2131560"/>
                        <a:ext cx="49680" cy="25884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199" name="Oval 385"/>
                      <p:cNvSpPr/>
                      <p:nvPr/>
                    </p:nvSpPr>
                    <p:spPr>
                      <a:xfrm rot="17100000">
                        <a:off x="5669640" y="2185560"/>
                        <a:ext cx="47880" cy="112320"/>
                      </a:xfrm>
                      <a:prstGeom prst="ellipse">
                        <a:avLst/>
                      </a:prstGeom>
                      <a:solidFill>
                        <a:srgbClr val="0000ff"/>
                      </a:solidFill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33120" bIns="3312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sp>
                  <p:nvSpPr>
                    <p:cNvPr id="200" name="AutoShape 386"/>
                    <p:cNvSpPr/>
                    <p:nvPr/>
                  </p:nvSpPr>
                  <p:spPr>
                    <a:xfrm rot="17100000">
                      <a:off x="5703840" y="2220480"/>
                      <a:ext cx="43920" cy="65160"/>
                    </a:xfrm>
                    <a:custGeom>
                      <a:avLst/>
                      <a:gdLst>
                        <a:gd name="textAreaLeft" fmla="*/ 2160 w 43920"/>
                        <a:gd name="textAreaRight" fmla="*/ 41760 w 43920"/>
                        <a:gd name="textAreaTop" fmla="*/ 2160 h 65160"/>
                        <a:gd name="textAreaBottom" fmla="*/ 63000 h 65160"/>
                      </a:gdLst>
                      <a:ahLst/>
                      <a:rect l="textAreaLeft" t="textAreaTop" r="textAreaRight" b="textAreaBottom"/>
                      <a:pathLst>
                        <a:path w="21600" h="31961">
                          <a:moveTo>
                            <a:pt x="3600" y="0"/>
                          </a:moveTo>
                          <a:arcTo wR="3600" hR="3600" stAng="16200000" swAng="-5400000"/>
                          <a:lnTo>
                            <a:pt x="0" y="28361"/>
                          </a:lnTo>
                          <a:arcTo wR="3600" hR="3600" stAng="10800000" swAng="-5400000"/>
                          <a:lnTo>
                            <a:pt x="18000" y="31961"/>
                          </a:lnTo>
                          <a:arcTo wR="3600" hR="3600" stAng="5400000" swAng="-5400000"/>
                          <a:lnTo>
                            <a:pt x="21600" y="3600"/>
                          </a:lnTo>
                          <a:arcTo wR="3600" hR="3600" stAng="0" swAng="-5400000"/>
                          <a:close/>
                        </a:path>
                      </a:pathLst>
                    </a:custGeom>
                    <a:solidFill>
                      <a:srgbClr val="0000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14040" bIns="1404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</p:grpSp>
          <p:grpSp>
            <p:nvGrpSpPr>
              <p:cNvPr id="201" name="Group 433"/>
              <p:cNvGrpSpPr/>
              <p:nvPr/>
            </p:nvGrpSpPr>
            <p:grpSpPr>
              <a:xfrm>
                <a:off x="3731760" y="1071360"/>
                <a:ext cx="1619280" cy="1685880"/>
                <a:chOff x="3731760" y="1071360"/>
                <a:chExt cx="1619280" cy="1685880"/>
              </a:xfrm>
            </p:grpSpPr>
            <p:sp>
              <p:nvSpPr>
                <p:cNvPr id="202" name="Oval 32"/>
                <p:cNvSpPr/>
                <p:nvPr/>
              </p:nvSpPr>
              <p:spPr>
                <a:xfrm>
                  <a:off x="3731760" y="1071360"/>
                  <a:ext cx="1619280" cy="168588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03" name="Group 75"/>
                <p:cNvGrpSpPr/>
                <p:nvPr/>
              </p:nvGrpSpPr>
              <p:grpSpPr>
                <a:xfrm>
                  <a:off x="4483800" y="1137960"/>
                  <a:ext cx="252000" cy="253800"/>
                  <a:chOff x="4483800" y="1137960"/>
                  <a:chExt cx="252000" cy="253800"/>
                </a:xfrm>
              </p:grpSpPr>
              <p:sp>
                <p:nvSpPr>
                  <p:cNvPr id="204" name="Line 76"/>
                  <p:cNvSpPr/>
                  <p:nvPr/>
                </p:nvSpPr>
                <p:spPr>
                  <a:xfrm flipH="1">
                    <a:off x="4505400" y="1137960"/>
                    <a:ext cx="92880" cy="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5" name="Line 77"/>
                  <p:cNvSpPr/>
                  <p:nvPr/>
                </p:nvSpPr>
                <p:spPr>
                  <a:xfrm flipH="1">
                    <a:off x="4734360" y="1275480"/>
                    <a:ext cx="1440" cy="9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5000" bIns="450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6" name="Line 78"/>
                  <p:cNvSpPr/>
                  <p:nvPr/>
                </p:nvSpPr>
                <p:spPr>
                  <a:xfrm flipH="1">
                    <a:off x="4483800" y="1207440"/>
                    <a:ext cx="183960" cy="1843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07" name="Group 79"/>
                <p:cNvGrpSpPr/>
                <p:nvPr/>
              </p:nvGrpSpPr>
              <p:grpSpPr>
                <a:xfrm>
                  <a:off x="3840120" y="1781640"/>
                  <a:ext cx="254520" cy="258120"/>
                  <a:chOff x="3840120" y="1781640"/>
                  <a:chExt cx="254520" cy="258120"/>
                </a:xfrm>
              </p:grpSpPr>
              <p:sp>
                <p:nvSpPr>
                  <p:cNvPr id="208" name="Line 80"/>
                  <p:cNvSpPr/>
                  <p:nvPr/>
                </p:nvSpPr>
                <p:spPr>
                  <a:xfrm flipH="1">
                    <a:off x="3906720" y="1785240"/>
                    <a:ext cx="183600" cy="183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9" name="Line 81"/>
                  <p:cNvSpPr/>
                  <p:nvPr/>
                </p:nvSpPr>
                <p:spPr>
                  <a:xfrm flipH="1">
                    <a:off x="3961800" y="2021400"/>
                    <a:ext cx="132840" cy="18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0" name="Line 82"/>
                  <p:cNvSpPr/>
                  <p:nvPr/>
                </p:nvSpPr>
                <p:spPr>
                  <a:xfrm flipH="1">
                    <a:off x="3840120" y="1781640"/>
                    <a:ext cx="26640" cy="11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11" name="Group 83"/>
                <p:cNvGrpSpPr/>
                <p:nvPr/>
              </p:nvGrpSpPr>
              <p:grpSpPr>
                <a:xfrm>
                  <a:off x="4447080" y="1817640"/>
                  <a:ext cx="252360" cy="250920"/>
                  <a:chOff x="4447080" y="1817640"/>
                  <a:chExt cx="252360" cy="250920"/>
                </a:xfrm>
              </p:grpSpPr>
              <p:sp>
                <p:nvSpPr>
                  <p:cNvPr id="212" name="Line 84"/>
                  <p:cNvSpPr/>
                  <p:nvPr/>
                </p:nvSpPr>
                <p:spPr>
                  <a:xfrm>
                    <a:off x="4447080" y="1955160"/>
                    <a:ext cx="0" cy="92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3" name="Line 85"/>
                  <p:cNvSpPr/>
                  <p:nvPr/>
                </p:nvSpPr>
                <p:spPr>
                  <a:xfrm>
                    <a:off x="4584240" y="1817640"/>
                    <a:ext cx="9180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4" name="Line 86"/>
                  <p:cNvSpPr/>
                  <p:nvPr/>
                </p:nvSpPr>
                <p:spPr>
                  <a:xfrm>
                    <a:off x="4516560" y="1885680"/>
                    <a:ext cx="182880" cy="1828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15" name="Group 87"/>
                <p:cNvGrpSpPr/>
                <p:nvPr/>
              </p:nvGrpSpPr>
              <p:grpSpPr>
                <a:xfrm>
                  <a:off x="4846320" y="2266200"/>
                  <a:ext cx="253800" cy="252000"/>
                  <a:chOff x="4846320" y="2266200"/>
                  <a:chExt cx="253800" cy="252000"/>
                </a:xfrm>
              </p:grpSpPr>
              <p:sp>
                <p:nvSpPr>
                  <p:cNvPr id="216" name="Line 88"/>
                  <p:cNvSpPr/>
                  <p:nvPr/>
                </p:nvSpPr>
                <p:spPr>
                  <a:xfrm flipH="1" flipV="1">
                    <a:off x="5099760" y="2287800"/>
                    <a:ext cx="360" cy="928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080" bIns="460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7" name="Line 89"/>
                  <p:cNvSpPr/>
                  <p:nvPr/>
                </p:nvSpPr>
                <p:spPr>
                  <a:xfrm flipH="1" flipV="1">
                    <a:off x="4870800" y="2516760"/>
                    <a:ext cx="9180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8" name="Line 90"/>
                  <p:cNvSpPr/>
                  <p:nvPr/>
                </p:nvSpPr>
                <p:spPr>
                  <a:xfrm flipH="1" flipV="1">
                    <a:off x="4846320" y="2266200"/>
                    <a:ext cx="184320" cy="183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19" name="Group 387"/>
                <p:cNvGrpSpPr/>
                <p:nvPr/>
              </p:nvGrpSpPr>
              <p:grpSpPr>
                <a:xfrm>
                  <a:off x="4523760" y="1926000"/>
                  <a:ext cx="550440" cy="511920"/>
                  <a:chOff x="4523760" y="1926000"/>
                  <a:chExt cx="550440" cy="511920"/>
                </a:xfrm>
              </p:grpSpPr>
              <p:sp>
                <p:nvSpPr>
                  <p:cNvPr id="220" name="Oval 388"/>
                  <p:cNvSpPr/>
                  <p:nvPr/>
                </p:nvSpPr>
                <p:spPr>
                  <a:xfrm rot="1800000">
                    <a:off x="4817520" y="1922760"/>
                    <a:ext cx="57240" cy="2602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1" name="Oval 389"/>
                  <p:cNvSpPr/>
                  <p:nvPr/>
                </p:nvSpPr>
                <p:spPr>
                  <a:xfrm rot="3600000">
                    <a:off x="4623480" y="2101680"/>
                    <a:ext cx="56880" cy="26352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2" name="Oval 390"/>
                  <p:cNvSpPr/>
                  <p:nvPr/>
                </p:nvSpPr>
                <p:spPr>
                  <a:xfrm rot="1800000">
                    <a:off x="4689720" y="2175120"/>
                    <a:ext cx="61920" cy="2649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223" name="Group 391"/>
                  <p:cNvGrpSpPr/>
                  <p:nvPr/>
                </p:nvGrpSpPr>
                <p:grpSpPr>
                  <a:xfrm>
                    <a:off x="4770720" y="2079720"/>
                    <a:ext cx="303480" cy="135000"/>
                    <a:chOff x="4770720" y="2079720"/>
                    <a:chExt cx="303480" cy="135000"/>
                  </a:xfrm>
                </p:grpSpPr>
                <p:sp>
                  <p:nvSpPr>
                    <p:cNvPr id="224" name="Oval 392"/>
                    <p:cNvSpPr/>
                    <p:nvPr/>
                  </p:nvSpPr>
                  <p:spPr>
                    <a:xfrm rot="4500000">
                      <a:off x="4888080" y="2001960"/>
                      <a:ext cx="61920" cy="29052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25" name="Oval 393"/>
                    <p:cNvSpPr/>
                    <p:nvPr/>
                  </p:nvSpPr>
                  <p:spPr>
                    <a:xfrm rot="4500000">
                      <a:off x="4979160" y="2061360"/>
                      <a:ext cx="54000" cy="1256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2120" bIns="42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26" name="AutoShape 394"/>
                    <p:cNvSpPr/>
                    <p:nvPr/>
                  </p:nvSpPr>
                  <p:spPr>
                    <a:xfrm rot="4500000">
                      <a:off x="4935600" y="2098800"/>
                      <a:ext cx="54000" cy="71280"/>
                    </a:xfrm>
                    <a:custGeom>
                      <a:avLst/>
                      <a:gdLst>
                        <a:gd name="textAreaLeft" fmla="*/ 2520 w 54000"/>
                        <a:gd name="textAreaRight" fmla="*/ 51480 w 54000"/>
                        <a:gd name="textAreaTop" fmla="*/ 2520 h 71280"/>
                        <a:gd name="textAreaBottom" fmla="*/ 68760 h 71280"/>
                      </a:gdLst>
                      <a:ahLst/>
                      <a:rect l="textAreaLeft" t="textAreaTop" r="textAreaRight" b="textAreaBottom"/>
                      <a:pathLst>
                        <a:path w="21600" h="28466">
                          <a:moveTo>
                            <a:pt x="3600" y="0"/>
                          </a:moveTo>
                          <a:arcTo wR="3600" hR="3600" stAng="16200000" swAng="-5400000"/>
                          <a:lnTo>
                            <a:pt x="0" y="24866"/>
                          </a:lnTo>
                          <a:arcTo wR="3600" hR="3600" stAng="10800000" swAng="-5400000"/>
                          <a:lnTo>
                            <a:pt x="18000" y="28466"/>
                          </a:lnTo>
                          <a:arcTo wR="3600" hR="3600" stAng="5400000" swAng="-5400000"/>
                          <a:lnTo>
                            <a:pt x="21600" y="3600"/>
                          </a:lnTo>
                          <a:arcTo wR="3600" hR="3600" stAng="0" swAng="-5400000"/>
                          <a:close/>
                        </a:path>
                      </a:pathLst>
                    </a:custGeom>
                    <a:solidFill>
                      <a:srgbClr val="ff00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19440" bIns="1944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27" name="Oval 395"/>
                  <p:cNvSpPr/>
                  <p:nvPr/>
                </p:nvSpPr>
                <p:spPr>
                  <a:xfrm rot="2700000">
                    <a:off x="4753080" y="2154960"/>
                    <a:ext cx="60480" cy="4752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2960" bIns="-12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28" name="Group 396"/>
                <p:cNvGrpSpPr/>
                <p:nvPr/>
              </p:nvGrpSpPr>
              <p:grpSpPr>
                <a:xfrm>
                  <a:off x="4002840" y="1308240"/>
                  <a:ext cx="524880" cy="508680"/>
                  <a:chOff x="4002840" y="1308240"/>
                  <a:chExt cx="524880" cy="508680"/>
                </a:xfrm>
              </p:grpSpPr>
              <p:sp>
                <p:nvSpPr>
                  <p:cNvPr id="229" name="Oval 397"/>
                  <p:cNvSpPr/>
                  <p:nvPr/>
                </p:nvSpPr>
                <p:spPr>
                  <a:xfrm flipH="1" rot="19800000">
                    <a:off x="4193640" y="1303560"/>
                    <a:ext cx="52200" cy="2606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0" name="Oval 398"/>
                  <p:cNvSpPr/>
                  <p:nvPr/>
                </p:nvSpPr>
                <p:spPr>
                  <a:xfrm flipH="1" rot="18000000">
                    <a:off x="4374720" y="1496520"/>
                    <a:ext cx="53280" cy="26100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1" name="Oval 399"/>
                  <p:cNvSpPr/>
                  <p:nvPr/>
                </p:nvSpPr>
                <p:spPr>
                  <a:xfrm flipH="1" rot="19800000">
                    <a:off x="4318200" y="1556280"/>
                    <a:ext cx="53640" cy="2649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232" name="Group 400"/>
                  <p:cNvGrpSpPr/>
                  <p:nvPr/>
                </p:nvGrpSpPr>
                <p:grpSpPr>
                  <a:xfrm>
                    <a:off x="4002840" y="1473840"/>
                    <a:ext cx="293400" cy="128520"/>
                    <a:chOff x="4002840" y="1473840"/>
                    <a:chExt cx="293400" cy="128520"/>
                  </a:xfrm>
                </p:grpSpPr>
                <p:grpSp>
                  <p:nvGrpSpPr>
                    <p:cNvPr id="233" name="Group 401"/>
                    <p:cNvGrpSpPr/>
                    <p:nvPr/>
                  </p:nvGrpSpPr>
                  <p:grpSpPr>
                    <a:xfrm>
                      <a:off x="4002840" y="1473840"/>
                      <a:ext cx="293400" cy="128520"/>
                      <a:chOff x="4002840" y="1473840"/>
                      <a:chExt cx="293400" cy="128520"/>
                    </a:xfrm>
                  </p:grpSpPr>
                  <p:sp>
                    <p:nvSpPr>
                      <p:cNvPr id="234" name="Oval 402"/>
                      <p:cNvSpPr/>
                      <p:nvPr/>
                    </p:nvSpPr>
                    <p:spPr>
                      <a:xfrm flipH="1" rot="17100000">
                        <a:off x="4121280" y="1393200"/>
                        <a:ext cx="55440" cy="28908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235" name="Oval 403"/>
                      <p:cNvSpPr/>
                      <p:nvPr/>
                    </p:nvSpPr>
                    <p:spPr>
                      <a:xfrm rot="17100000">
                        <a:off x="4043880" y="1453320"/>
                        <a:ext cx="53640" cy="125640"/>
                      </a:xfrm>
                      <a:prstGeom prst="ellipse">
                        <a:avLst/>
                      </a:prstGeom>
                      <a:solidFill>
                        <a:srgbClr val="0000ff"/>
                      </a:solidFill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2120" bIns="4212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sp>
                  <p:nvSpPr>
                    <p:cNvPr id="236" name="AutoShape 404"/>
                    <p:cNvSpPr/>
                    <p:nvPr/>
                  </p:nvSpPr>
                  <p:spPr>
                    <a:xfrm rot="17100000">
                      <a:off x="4082400" y="1492560"/>
                      <a:ext cx="48960" cy="73080"/>
                    </a:xfrm>
                    <a:custGeom>
                      <a:avLst/>
                      <a:gdLst>
                        <a:gd name="textAreaLeft" fmla="*/ 2160 w 48960"/>
                        <a:gd name="textAreaRight" fmla="*/ 46800 w 48960"/>
                        <a:gd name="textAreaTop" fmla="*/ 2160 h 73080"/>
                        <a:gd name="textAreaBottom" fmla="*/ 70920 h 73080"/>
                      </a:gdLst>
                      <a:ahLst/>
                      <a:rect l="textAreaLeft" t="textAreaTop" r="textAreaRight" b="textAreaBottom"/>
                      <a:pathLst>
                        <a:path w="21600" h="32164">
                          <a:moveTo>
                            <a:pt x="3600" y="0"/>
                          </a:moveTo>
                          <a:arcTo wR="3600" hR="3600" stAng="16200000" swAng="-5400000"/>
                          <a:lnTo>
                            <a:pt x="0" y="28564"/>
                          </a:lnTo>
                          <a:arcTo wR="3600" hR="3600" stAng="10800000" swAng="-5400000"/>
                          <a:lnTo>
                            <a:pt x="18000" y="32164"/>
                          </a:lnTo>
                          <a:arcTo wR="3600" hR="3600" stAng="5400000" swAng="-5400000"/>
                          <a:lnTo>
                            <a:pt x="21600" y="3600"/>
                          </a:lnTo>
                          <a:arcTo wR="3600" hR="3600" stAng="0" swAng="-5400000"/>
                          <a:close/>
                        </a:path>
                      </a:pathLst>
                    </a:custGeom>
                    <a:solidFill>
                      <a:srgbClr val="0000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1960" bIns="219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37" name="Oval 405"/>
                  <p:cNvSpPr/>
                  <p:nvPr/>
                </p:nvSpPr>
                <p:spPr>
                  <a:xfrm flipH="1" rot="18900000">
                    <a:off x="4244400" y="1545120"/>
                    <a:ext cx="56880" cy="47520"/>
                  </a:xfrm>
                  <a:prstGeom prst="ellipse">
                    <a:avLst/>
                  </a:pr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2960" bIns="-12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38" name="Group 406"/>
              <p:cNvGrpSpPr/>
              <p:nvPr/>
            </p:nvGrpSpPr>
            <p:grpSpPr>
              <a:xfrm>
                <a:off x="8260200" y="2078640"/>
                <a:ext cx="408600" cy="315360"/>
                <a:chOff x="8260200" y="2078640"/>
                <a:chExt cx="408600" cy="315360"/>
              </a:xfrm>
            </p:grpSpPr>
            <p:sp>
              <p:nvSpPr>
                <p:cNvPr id="239" name="Oval 407"/>
                <p:cNvSpPr/>
                <p:nvPr/>
              </p:nvSpPr>
              <p:spPr>
                <a:xfrm rot="1800000">
                  <a:off x="8316720" y="2153160"/>
                  <a:ext cx="57240" cy="24264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40" name="Group 408"/>
                <p:cNvGrpSpPr/>
                <p:nvPr/>
              </p:nvGrpSpPr>
              <p:grpSpPr>
                <a:xfrm>
                  <a:off x="8395560" y="2078640"/>
                  <a:ext cx="273240" cy="121680"/>
                  <a:chOff x="8395560" y="2078640"/>
                  <a:chExt cx="273240" cy="121680"/>
                </a:xfrm>
              </p:grpSpPr>
              <p:sp>
                <p:nvSpPr>
                  <p:cNvPr id="241" name="Oval 409"/>
                  <p:cNvSpPr/>
                  <p:nvPr/>
                </p:nvSpPr>
                <p:spPr>
                  <a:xfrm rot="4500000">
                    <a:off x="8501040" y="2008440"/>
                    <a:ext cx="55800" cy="2620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2" name="Oval 410"/>
                  <p:cNvSpPr/>
                  <p:nvPr/>
                </p:nvSpPr>
                <p:spPr>
                  <a:xfrm rot="4500000">
                    <a:off x="8583480" y="2061720"/>
                    <a:ext cx="48600" cy="1130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3120" bIns="33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3" name="AutoShape 411"/>
                  <p:cNvSpPr/>
                  <p:nvPr/>
                </p:nvSpPr>
                <p:spPr>
                  <a:xfrm rot="4500000">
                    <a:off x="8544240" y="2095560"/>
                    <a:ext cx="48600" cy="64080"/>
                  </a:xfrm>
                  <a:custGeom>
                    <a:avLst/>
                    <a:gdLst>
                      <a:gd name="textAreaLeft" fmla="*/ 2160 w 48600"/>
                      <a:gd name="textAreaRight" fmla="*/ 46440 w 48600"/>
                      <a:gd name="textAreaTop" fmla="*/ 2160 h 64080"/>
                      <a:gd name="textAreaBottom" fmla="*/ 61920 h 64080"/>
                    </a:gdLst>
                    <a:ahLst/>
                    <a:rect l="textAreaLeft" t="textAreaTop" r="textAreaRight" b="textAreaBottom"/>
                    <a:pathLst>
                      <a:path w="21600" h="28429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4829"/>
                        </a:lnTo>
                        <a:arcTo wR="3600" hR="3600" stAng="10800000" swAng="-5400000"/>
                        <a:lnTo>
                          <a:pt x="18000" y="28429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ff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2960" bIns="12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44" name="Group 412"/>
              <p:cNvGrpSpPr/>
              <p:nvPr/>
            </p:nvGrpSpPr>
            <p:grpSpPr>
              <a:xfrm>
                <a:off x="3958920" y="4817160"/>
                <a:ext cx="524880" cy="508320"/>
                <a:chOff x="3958920" y="4817160"/>
                <a:chExt cx="524880" cy="508320"/>
              </a:xfrm>
            </p:grpSpPr>
            <p:sp>
              <p:nvSpPr>
                <p:cNvPr id="245" name="Oval 413"/>
                <p:cNvSpPr/>
                <p:nvPr/>
              </p:nvSpPr>
              <p:spPr>
                <a:xfrm flipH="1" rot="19800000">
                  <a:off x="4149720" y="4812480"/>
                  <a:ext cx="52200" cy="26064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6" name="Oval 414"/>
                <p:cNvSpPr/>
                <p:nvPr/>
              </p:nvSpPr>
              <p:spPr>
                <a:xfrm flipH="1" rot="18000000">
                  <a:off x="4330800" y="5005440"/>
                  <a:ext cx="53280" cy="26100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7" name="Oval 415"/>
                <p:cNvSpPr/>
                <p:nvPr/>
              </p:nvSpPr>
              <p:spPr>
                <a:xfrm flipH="1" rot="19800000">
                  <a:off x="4274280" y="5064840"/>
                  <a:ext cx="53640" cy="26496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48" name="Group 416"/>
                <p:cNvGrpSpPr/>
                <p:nvPr/>
              </p:nvGrpSpPr>
              <p:grpSpPr>
                <a:xfrm>
                  <a:off x="3958920" y="4982400"/>
                  <a:ext cx="293400" cy="128520"/>
                  <a:chOff x="3958920" y="4982400"/>
                  <a:chExt cx="293400" cy="128520"/>
                </a:xfrm>
              </p:grpSpPr>
              <p:grpSp>
                <p:nvGrpSpPr>
                  <p:cNvPr id="249" name="Group 417"/>
                  <p:cNvGrpSpPr/>
                  <p:nvPr/>
                </p:nvGrpSpPr>
                <p:grpSpPr>
                  <a:xfrm>
                    <a:off x="3958920" y="4982400"/>
                    <a:ext cx="293400" cy="128520"/>
                    <a:chOff x="3958920" y="4982400"/>
                    <a:chExt cx="293400" cy="128520"/>
                  </a:xfrm>
                </p:grpSpPr>
                <p:sp>
                  <p:nvSpPr>
                    <p:cNvPr id="250" name="Oval 418"/>
                    <p:cNvSpPr/>
                    <p:nvPr/>
                  </p:nvSpPr>
                  <p:spPr>
                    <a:xfrm flipH="1" rot="17100000">
                      <a:off x="4077360" y="4901760"/>
                      <a:ext cx="55440" cy="28908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51" name="Oval 419"/>
                    <p:cNvSpPr/>
                    <p:nvPr/>
                  </p:nvSpPr>
                  <p:spPr>
                    <a:xfrm rot="17100000">
                      <a:off x="3999960" y="4962240"/>
                      <a:ext cx="53640" cy="12564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2120" bIns="42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52" name="AutoShape 420"/>
                  <p:cNvSpPr/>
                  <p:nvPr/>
                </p:nvSpPr>
                <p:spPr>
                  <a:xfrm rot="17100000">
                    <a:off x="4038120" y="5001480"/>
                    <a:ext cx="48960" cy="73080"/>
                  </a:xfrm>
                  <a:custGeom>
                    <a:avLst/>
                    <a:gdLst>
                      <a:gd name="textAreaLeft" fmla="*/ 2160 w 48960"/>
                      <a:gd name="textAreaRight" fmla="*/ 46800 w 48960"/>
                      <a:gd name="textAreaTop" fmla="*/ 2160 h 73080"/>
                      <a:gd name="textAreaBottom" fmla="*/ 70920 h 73080"/>
                    </a:gdLst>
                    <a:ahLst/>
                    <a:rect l="textAreaLeft" t="textAreaTop" r="textAreaRight" b="textAreaBottom"/>
                    <a:pathLst>
                      <a:path w="21600" h="32164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8564"/>
                        </a:lnTo>
                        <a:arcTo wR="3600" hR="3600" stAng="10800000" swAng="-5400000"/>
                        <a:lnTo>
                          <a:pt x="18000" y="32164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0000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1960" bIns="21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253" name="Oval 421"/>
                <p:cNvSpPr/>
                <p:nvPr/>
              </p:nvSpPr>
              <p:spPr>
                <a:xfrm flipH="1" rot="18900000">
                  <a:off x="4200480" y="5054040"/>
                  <a:ext cx="56880" cy="47520"/>
                </a:xfrm>
                <a:prstGeom prst="ellipse">
                  <a:avLst/>
                </a:prstGeom>
                <a:solidFill>
                  <a:srgbClr val="1f497d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2960" bIns="-129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54" name="Group 422"/>
              <p:cNvGrpSpPr/>
              <p:nvPr/>
            </p:nvGrpSpPr>
            <p:grpSpPr>
              <a:xfrm>
                <a:off x="4408920" y="5225400"/>
                <a:ext cx="512280" cy="550440"/>
                <a:chOff x="4408920" y="5225400"/>
                <a:chExt cx="512280" cy="550440"/>
              </a:xfrm>
            </p:grpSpPr>
            <p:sp>
              <p:nvSpPr>
                <p:cNvPr id="255" name="Oval 423"/>
                <p:cNvSpPr/>
                <p:nvPr/>
              </p:nvSpPr>
              <p:spPr>
                <a:xfrm rot="18000000">
                  <a:off x="4507200" y="5322960"/>
                  <a:ext cx="57240" cy="26028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6" name="Oval 424"/>
                <p:cNvSpPr/>
                <p:nvPr/>
              </p:nvSpPr>
              <p:spPr>
                <a:xfrm rot="19800000">
                  <a:off x="4688280" y="5515560"/>
                  <a:ext cx="56880" cy="26352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7" name="Oval 425"/>
                <p:cNvSpPr/>
                <p:nvPr/>
              </p:nvSpPr>
              <p:spPr>
                <a:xfrm rot="18000000">
                  <a:off x="4759920" y="5446080"/>
                  <a:ext cx="61920" cy="26496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58" name="Group 426"/>
                <p:cNvGrpSpPr/>
                <p:nvPr/>
              </p:nvGrpSpPr>
              <p:grpSpPr>
                <a:xfrm>
                  <a:off x="4562640" y="5225400"/>
                  <a:ext cx="135000" cy="303120"/>
                  <a:chOff x="4562640" y="5225400"/>
                  <a:chExt cx="135000" cy="303120"/>
                </a:xfrm>
              </p:grpSpPr>
              <p:sp>
                <p:nvSpPr>
                  <p:cNvPr id="259" name="Oval 427"/>
                  <p:cNvSpPr/>
                  <p:nvPr/>
                </p:nvSpPr>
                <p:spPr>
                  <a:xfrm rot="20700000">
                    <a:off x="4599000" y="5234400"/>
                    <a:ext cx="61920" cy="29052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0" name="Oval 428"/>
                  <p:cNvSpPr/>
                  <p:nvPr/>
                </p:nvSpPr>
                <p:spPr>
                  <a:xfrm rot="20700000">
                    <a:off x="4580280" y="5230080"/>
                    <a:ext cx="54000" cy="1256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2120" bIns="42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1" name="AutoShape 429"/>
                  <p:cNvSpPr/>
                  <p:nvPr/>
                </p:nvSpPr>
                <p:spPr>
                  <a:xfrm rot="20700000">
                    <a:off x="4590720" y="5301000"/>
                    <a:ext cx="54000" cy="71280"/>
                  </a:xfrm>
                  <a:custGeom>
                    <a:avLst/>
                    <a:gdLst>
                      <a:gd name="textAreaLeft" fmla="*/ 2520 w 54000"/>
                      <a:gd name="textAreaRight" fmla="*/ 51480 w 54000"/>
                      <a:gd name="textAreaTop" fmla="*/ 2520 h 71280"/>
                      <a:gd name="textAreaBottom" fmla="*/ 68760 h 71280"/>
                    </a:gdLst>
                    <a:ahLst/>
                    <a:rect l="textAreaLeft" t="textAreaTop" r="textAreaRight" b="textAreaBottom"/>
                    <a:pathLst>
                      <a:path w="21600" h="28466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4866"/>
                        </a:lnTo>
                        <a:arcTo wR="3600" hR="3600" stAng="10800000" swAng="-5400000"/>
                        <a:lnTo>
                          <a:pt x="18000" y="28466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ff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9440" bIns="194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262" name="Oval 430"/>
                <p:cNvSpPr/>
                <p:nvPr/>
              </p:nvSpPr>
              <p:spPr>
                <a:xfrm rot="18900000">
                  <a:off x="4631400" y="5492160"/>
                  <a:ext cx="60480" cy="4752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2960" bIns="-129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63" name="Group 434"/>
              <p:cNvGrpSpPr/>
              <p:nvPr/>
            </p:nvGrpSpPr>
            <p:grpSpPr>
              <a:xfrm>
                <a:off x="7505280" y="2251440"/>
                <a:ext cx="383040" cy="302400"/>
                <a:chOff x="7505280" y="2251440"/>
                <a:chExt cx="383040" cy="302400"/>
              </a:xfrm>
            </p:grpSpPr>
            <p:sp>
              <p:nvSpPr>
                <p:cNvPr id="264" name="Oval 435"/>
                <p:cNvSpPr/>
                <p:nvPr/>
              </p:nvSpPr>
              <p:spPr>
                <a:xfrm flipH="1" rot="19800000">
                  <a:off x="7785360" y="2322720"/>
                  <a:ext cx="47520" cy="2347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65" name="Group 436"/>
                <p:cNvGrpSpPr/>
                <p:nvPr/>
              </p:nvGrpSpPr>
              <p:grpSpPr>
                <a:xfrm>
                  <a:off x="7505280" y="2251440"/>
                  <a:ext cx="262800" cy="114840"/>
                  <a:chOff x="7505280" y="2251440"/>
                  <a:chExt cx="262800" cy="114840"/>
                </a:xfrm>
              </p:grpSpPr>
              <p:grpSp>
                <p:nvGrpSpPr>
                  <p:cNvPr id="266" name="Group 437"/>
                  <p:cNvGrpSpPr/>
                  <p:nvPr/>
                </p:nvGrpSpPr>
                <p:grpSpPr>
                  <a:xfrm>
                    <a:off x="7505280" y="2251440"/>
                    <a:ext cx="262800" cy="114840"/>
                    <a:chOff x="7505280" y="2251440"/>
                    <a:chExt cx="262800" cy="114840"/>
                  </a:xfrm>
                </p:grpSpPr>
                <p:sp>
                  <p:nvSpPr>
                    <p:cNvPr id="267" name="Oval 438"/>
                    <p:cNvSpPr/>
                    <p:nvPr/>
                  </p:nvSpPr>
                  <p:spPr>
                    <a:xfrm flipH="1" rot="17100000">
                      <a:off x="7611480" y="2179440"/>
                      <a:ext cx="49680" cy="2588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68" name="Oval 439"/>
                    <p:cNvSpPr/>
                    <p:nvPr/>
                  </p:nvSpPr>
                  <p:spPr>
                    <a:xfrm rot="17100000">
                      <a:off x="7541640" y="2233440"/>
                      <a:ext cx="48240" cy="11232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33120" bIns="33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69" name="AutoShape 440"/>
                  <p:cNvSpPr/>
                  <p:nvPr/>
                </p:nvSpPr>
                <p:spPr>
                  <a:xfrm rot="17100000">
                    <a:off x="7575840" y="2268720"/>
                    <a:ext cx="43920" cy="65160"/>
                  </a:xfrm>
                  <a:custGeom>
                    <a:avLst/>
                    <a:gdLst>
                      <a:gd name="textAreaLeft" fmla="*/ 2160 w 43920"/>
                      <a:gd name="textAreaRight" fmla="*/ 41760 w 43920"/>
                      <a:gd name="textAreaTop" fmla="*/ 2160 h 65160"/>
                      <a:gd name="textAreaBottom" fmla="*/ 63000 h 65160"/>
                    </a:gdLst>
                    <a:ahLst/>
                    <a:rect l="textAreaLeft" t="textAreaTop" r="textAreaRight" b="textAreaBottom"/>
                    <a:pathLst>
                      <a:path w="21600" h="31961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8361"/>
                        </a:lnTo>
                        <a:arcTo wR="3600" hR="3600" stAng="10800000" swAng="-5400000"/>
                        <a:lnTo>
                          <a:pt x="18000" y="31961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0000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4040" bIns="140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70" name="Group 442"/>
              <p:cNvGrpSpPr/>
              <p:nvPr/>
            </p:nvGrpSpPr>
            <p:grpSpPr>
              <a:xfrm>
                <a:off x="5465160" y="5437800"/>
                <a:ext cx="383040" cy="302400"/>
                <a:chOff x="5465160" y="5437800"/>
                <a:chExt cx="383040" cy="302400"/>
              </a:xfrm>
            </p:grpSpPr>
            <p:sp>
              <p:nvSpPr>
                <p:cNvPr id="271" name="Oval 443"/>
                <p:cNvSpPr/>
                <p:nvPr/>
              </p:nvSpPr>
              <p:spPr>
                <a:xfrm flipH="1" rot="19800000">
                  <a:off x="5745240" y="5509080"/>
                  <a:ext cx="47520" cy="2347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72" name="Group 444"/>
                <p:cNvGrpSpPr/>
                <p:nvPr/>
              </p:nvGrpSpPr>
              <p:grpSpPr>
                <a:xfrm>
                  <a:off x="5465160" y="5437800"/>
                  <a:ext cx="262800" cy="114840"/>
                  <a:chOff x="5465160" y="5437800"/>
                  <a:chExt cx="262800" cy="114840"/>
                </a:xfrm>
              </p:grpSpPr>
              <p:grpSp>
                <p:nvGrpSpPr>
                  <p:cNvPr id="273" name="Group 445"/>
                  <p:cNvGrpSpPr/>
                  <p:nvPr/>
                </p:nvGrpSpPr>
                <p:grpSpPr>
                  <a:xfrm>
                    <a:off x="5465160" y="5437800"/>
                    <a:ext cx="262800" cy="114840"/>
                    <a:chOff x="5465160" y="5437800"/>
                    <a:chExt cx="262800" cy="114840"/>
                  </a:xfrm>
                </p:grpSpPr>
                <p:sp>
                  <p:nvSpPr>
                    <p:cNvPr id="274" name="Oval 446"/>
                    <p:cNvSpPr/>
                    <p:nvPr/>
                  </p:nvSpPr>
                  <p:spPr>
                    <a:xfrm flipH="1" rot="17100000">
                      <a:off x="5571360" y="5365800"/>
                      <a:ext cx="49680" cy="2588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75" name="Oval 447"/>
                    <p:cNvSpPr/>
                    <p:nvPr/>
                  </p:nvSpPr>
                  <p:spPr>
                    <a:xfrm rot="17100000">
                      <a:off x="5501520" y="5419800"/>
                      <a:ext cx="48240" cy="11232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33120" bIns="33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76" name="AutoShape 448"/>
                  <p:cNvSpPr/>
                  <p:nvPr/>
                </p:nvSpPr>
                <p:spPr>
                  <a:xfrm rot="17100000">
                    <a:off x="5535720" y="5455080"/>
                    <a:ext cx="43920" cy="65160"/>
                  </a:xfrm>
                  <a:custGeom>
                    <a:avLst/>
                    <a:gdLst>
                      <a:gd name="textAreaLeft" fmla="*/ 2160 w 43920"/>
                      <a:gd name="textAreaRight" fmla="*/ 41760 w 43920"/>
                      <a:gd name="textAreaTop" fmla="*/ 2160 h 65160"/>
                      <a:gd name="textAreaBottom" fmla="*/ 63000 h 65160"/>
                    </a:gdLst>
                    <a:ahLst/>
                    <a:rect l="textAreaLeft" t="textAreaTop" r="textAreaRight" b="textAreaBottom"/>
                    <a:pathLst>
                      <a:path w="21600" h="31961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8361"/>
                        </a:lnTo>
                        <a:arcTo wR="3600" hR="3600" stAng="10800000" swAng="-5400000"/>
                        <a:lnTo>
                          <a:pt x="18000" y="31961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0000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4040" bIns="140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77" name="Group 449"/>
              <p:cNvGrpSpPr/>
              <p:nvPr/>
            </p:nvGrpSpPr>
            <p:grpSpPr>
              <a:xfrm>
                <a:off x="7954200" y="4892760"/>
                <a:ext cx="315360" cy="408600"/>
                <a:chOff x="7954200" y="4892760"/>
                <a:chExt cx="315360" cy="408600"/>
              </a:xfrm>
            </p:grpSpPr>
            <p:sp>
              <p:nvSpPr>
                <p:cNvPr id="278" name="Oval 450"/>
                <p:cNvSpPr/>
                <p:nvPr/>
              </p:nvSpPr>
              <p:spPr>
                <a:xfrm rot="18000000">
                  <a:off x="8121600" y="5094360"/>
                  <a:ext cx="57240" cy="24264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79" name="Group 451"/>
                <p:cNvGrpSpPr/>
                <p:nvPr/>
              </p:nvGrpSpPr>
              <p:grpSpPr>
                <a:xfrm>
                  <a:off x="7954200" y="4892760"/>
                  <a:ext cx="121680" cy="273240"/>
                  <a:chOff x="7954200" y="4892760"/>
                  <a:chExt cx="121680" cy="273240"/>
                </a:xfrm>
              </p:grpSpPr>
              <p:sp>
                <p:nvSpPr>
                  <p:cNvPr id="280" name="Oval 452"/>
                  <p:cNvSpPr/>
                  <p:nvPr/>
                </p:nvSpPr>
                <p:spPr>
                  <a:xfrm rot="20700000">
                    <a:off x="7986960" y="4901040"/>
                    <a:ext cx="55800" cy="2620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1" name="Oval 453"/>
                  <p:cNvSpPr/>
                  <p:nvPr/>
                </p:nvSpPr>
                <p:spPr>
                  <a:xfrm rot="20700000">
                    <a:off x="7969680" y="4897080"/>
                    <a:ext cx="48600" cy="1130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3120" bIns="33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2" name="AutoShape 454"/>
                  <p:cNvSpPr/>
                  <p:nvPr/>
                </p:nvSpPr>
                <p:spPr>
                  <a:xfrm rot="20700000">
                    <a:off x="7978680" y="4960800"/>
                    <a:ext cx="48600" cy="64080"/>
                  </a:xfrm>
                  <a:custGeom>
                    <a:avLst/>
                    <a:gdLst>
                      <a:gd name="textAreaLeft" fmla="*/ 2160 w 48600"/>
                      <a:gd name="textAreaRight" fmla="*/ 46440 w 48600"/>
                      <a:gd name="textAreaTop" fmla="*/ 2160 h 64080"/>
                      <a:gd name="textAreaBottom" fmla="*/ 61920 h 64080"/>
                    </a:gdLst>
                    <a:ahLst/>
                    <a:rect l="textAreaLeft" t="textAreaTop" r="textAreaRight" b="textAreaBottom"/>
                    <a:pathLst>
                      <a:path w="21600" h="28429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4829"/>
                        </a:lnTo>
                        <a:arcTo wR="3600" hR="3600" stAng="10800000" swAng="-5400000"/>
                        <a:lnTo>
                          <a:pt x="18000" y="28429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ff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2960" bIns="12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83" name="Group 455"/>
              <p:cNvGrpSpPr/>
              <p:nvPr/>
            </p:nvGrpSpPr>
            <p:grpSpPr>
              <a:xfrm>
                <a:off x="7308360" y="5688720"/>
                <a:ext cx="383040" cy="302400"/>
                <a:chOff x="7308360" y="5688720"/>
                <a:chExt cx="383040" cy="302400"/>
              </a:xfrm>
            </p:grpSpPr>
            <p:sp>
              <p:nvSpPr>
                <p:cNvPr id="284" name="Oval 456"/>
                <p:cNvSpPr/>
                <p:nvPr/>
              </p:nvSpPr>
              <p:spPr>
                <a:xfrm flipH="1" rot="19800000">
                  <a:off x="7588440" y="5760000"/>
                  <a:ext cx="47520" cy="2347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85" name="Group 457"/>
                <p:cNvGrpSpPr/>
                <p:nvPr/>
              </p:nvGrpSpPr>
              <p:grpSpPr>
                <a:xfrm>
                  <a:off x="7308360" y="5688720"/>
                  <a:ext cx="262800" cy="114840"/>
                  <a:chOff x="7308360" y="5688720"/>
                  <a:chExt cx="262800" cy="114840"/>
                </a:xfrm>
              </p:grpSpPr>
              <p:grpSp>
                <p:nvGrpSpPr>
                  <p:cNvPr id="286" name="Group 458"/>
                  <p:cNvGrpSpPr/>
                  <p:nvPr/>
                </p:nvGrpSpPr>
                <p:grpSpPr>
                  <a:xfrm>
                    <a:off x="7308360" y="5688720"/>
                    <a:ext cx="262800" cy="114840"/>
                    <a:chOff x="7308360" y="5688720"/>
                    <a:chExt cx="262800" cy="114840"/>
                  </a:xfrm>
                </p:grpSpPr>
                <p:sp>
                  <p:nvSpPr>
                    <p:cNvPr id="287" name="Oval 459"/>
                    <p:cNvSpPr/>
                    <p:nvPr/>
                  </p:nvSpPr>
                  <p:spPr>
                    <a:xfrm flipH="1" rot="17100000">
                      <a:off x="7414560" y="5616720"/>
                      <a:ext cx="49680" cy="2588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88" name="Oval 460"/>
                    <p:cNvSpPr/>
                    <p:nvPr/>
                  </p:nvSpPr>
                  <p:spPr>
                    <a:xfrm rot="17100000">
                      <a:off x="7344720" y="5670720"/>
                      <a:ext cx="48240" cy="11232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33120" bIns="331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289" name="AutoShape 461"/>
                  <p:cNvSpPr/>
                  <p:nvPr/>
                </p:nvSpPr>
                <p:spPr>
                  <a:xfrm rot="17100000">
                    <a:off x="7378920" y="5706000"/>
                    <a:ext cx="43920" cy="65160"/>
                  </a:xfrm>
                  <a:custGeom>
                    <a:avLst/>
                    <a:gdLst>
                      <a:gd name="textAreaLeft" fmla="*/ 2160 w 43920"/>
                      <a:gd name="textAreaRight" fmla="*/ 41760 w 43920"/>
                      <a:gd name="textAreaTop" fmla="*/ 2160 h 65160"/>
                      <a:gd name="textAreaBottom" fmla="*/ 63000 h 65160"/>
                    </a:gdLst>
                    <a:ahLst/>
                    <a:rect l="textAreaLeft" t="textAreaTop" r="textAreaRight" b="textAreaBottom"/>
                    <a:pathLst>
                      <a:path w="21600" h="31961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8361"/>
                        </a:lnTo>
                        <a:arcTo wR="3600" hR="3600" stAng="10800000" swAng="-5400000"/>
                        <a:lnTo>
                          <a:pt x="18000" y="31961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0000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4040" bIns="1404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90" name="Group 462"/>
              <p:cNvGrpSpPr/>
              <p:nvPr/>
            </p:nvGrpSpPr>
            <p:grpSpPr>
              <a:xfrm>
                <a:off x="6658920" y="4965840"/>
                <a:ext cx="315360" cy="408600"/>
                <a:chOff x="6658920" y="4965840"/>
                <a:chExt cx="315360" cy="408600"/>
              </a:xfrm>
            </p:grpSpPr>
            <p:sp>
              <p:nvSpPr>
                <p:cNvPr id="291" name="Oval 463"/>
                <p:cNvSpPr/>
                <p:nvPr/>
              </p:nvSpPr>
              <p:spPr>
                <a:xfrm rot="18000000">
                  <a:off x="6826320" y="5167440"/>
                  <a:ext cx="57240" cy="24264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92" name="Group 464"/>
                <p:cNvGrpSpPr/>
                <p:nvPr/>
              </p:nvGrpSpPr>
              <p:grpSpPr>
                <a:xfrm>
                  <a:off x="6658920" y="4965840"/>
                  <a:ext cx="121680" cy="273240"/>
                  <a:chOff x="6658920" y="4965840"/>
                  <a:chExt cx="121680" cy="273240"/>
                </a:xfrm>
              </p:grpSpPr>
              <p:sp>
                <p:nvSpPr>
                  <p:cNvPr id="293" name="Oval 465"/>
                  <p:cNvSpPr/>
                  <p:nvPr/>
                </p:nvSpPr>
                <p:spPr>
                  <a:xfrm rot="20700000">
                    <a:off x="6691680" y="4974120"/>
                    <a:ext cx="55800" cy="26208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4" name="Oval 466"/>
                  <p:cNvSpPr/>
                  <p:nvPr/>
                </p:nvSpPr>
                <p:spPr>
                  <a:xfrm rot="20700000">
                    <a:off x="6674400" y="4970160"/>
                    <a:ext cx="48600" cy="1130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3120" bIns="33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5" name="AutoShape 467"/>
                  <p:cNvSpPr/>
                  <p:nvPr/>
                </p:nvSpPr>
                <p:spPr>
                  <a:xfrm rot="20700000">
                    <a:off x="6683400" y="5033880"/>
                    <a:ext cx="48600" cy="64080"/>
                  </a:xfrm>
                  <a:custGeom>
                    <a:avLst/>
                    <a:gdLst>
                      <a:gd name="textAreaLeft" fmla="*/ 2160 w 48600"/>
                      <a:gd name="textAreaRight" fmla="*/ 46440 w 48600"/>
                      <a:gd name="textAreaTop" fmla="*/ 2160 h 64080"/>
                      <a:gd name="textAreaBottom" fmla="*/ 61920 h 64080"/>
                    </a:gdLst>
                    <a:ahLst/>
                    <a:rect l="textAreaLeft" t="textAreaTop" r="textAreaRight" b="textAreaBottom"/>
                    <a:pathLst>
                      <a:path w="21600" h="28429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4829"/>
                        </a:lnTo>
                        <a:arcTo wR="3600" hR="3600" stAng="10800000" swAng="-5400000"/>
                        <a:lnTo>
                          <a:pt x="18000" y="28429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solidFill>
                    <a:srgbClr val="ff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2960" bIns="129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4T07:24:07Z</dcterms:created>
  <dc:creator>ANNA</dc:creator>
  <dc:description/>
  <dc:language>en-US</dc:language>
  <cp:lastModifiedBy>ANNA</cp:lastModifiedBy>
  <dcterms:modified xsi:type="dcterms:W3CDTF">2011-03-24T08:11:16Z</dcterms:modified>
  <cp:revision>1</cp:revision>
  <dc:subject/>
  <dc:title>PowerPoint Presentation</dc:title>
</cp:coreProperties>
</file>